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62" r:id="rId4"/>
    <p:sldId id="271" r:id="rId5"/>
    <p:sldId id="273" r:id="rId6"/>
    <p:sldId id="274" r:id="rId7"/>
    <p:sldId id="272" r:id="rId8"/>
    <p:sldId id="270" r:id="rId9"/>
    <p:sldId id="256" r:id="rId10"/>
  </p:sldIdLst>
  <p:sldSz cx="12192000" cy="6858000"/>
  <p:notesSz cx="7104063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12" autoAdjust="0"/>
    <p:restoredTop sz="94660"/>
  </p:normalViewPr>
  <p:slideViewPr>
    <p:cSldViewPr snapToGrid="0">
      <p:cViewPr varScale="1">
        <p:scale>
          <a:sx n="89" d="100"/>
          <a:sy n="89" d="100"/>
        </p:scale>
        <p:origin x="2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image" Target="../media/image2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image" Target="../media/image11.emf"/><Relationship Id="rId4" Type="http://schemas.openxmlformats.org/officeDocument/2006/relationships/image" Target="../media/image14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5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6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image" Target="../media/image17.emf"/><Relationship Id="rId5" Type="http://schemas.openxmlformats.org/officeDocument/2006/relationships/image" Target="../media/image21.emf"/><Relationship Id="rId4" Type="http://schemas.openxmlformats.org/officeDocument/2006/relationships/image" Target="../media/image20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22.e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2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DA66E-B52C-48E6-B222-2B34CF164A61}" type="datetimeFigureOut">
              <a:rPr lang="en-AU" smtClean="0"/>
              <a:t>5/01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234F9-21FF-4935-A60D-E9940CAC81E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17142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DA66E-B52C-48E6-B222-2B34CF164A61}" type="datetimeFigureOut">
              <a:rPr lang="en-AU" smtClean="0"/>
              <a:t>5/01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234F9-21FF-4935-A60D-E9940CAC81E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95923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DA66E-B52C-48E6-B222-2B34CF164A61}" type="datetimeFigureOut">
              <a:rPr lang="en-AU" smtClean="0"/>
              <a:t>5/01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234F9-21FF-4935-A60D-E9940CAC81E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535544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DA66E-B52C-48E6-B222-2B34CF164A61}" type="datetimeFigureOut">
              <a:rPr lang="en-AU" smtClean="0"/>
              <a:t>5/01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234F9-21FF-4935-A60D-E9940CAC81E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858748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DA66E-B52C-48E6-B222-2B34CF164A61}" type="datetimeFigureOut">
              <a:rPr lang="en-AU" smtClean="0"/>
              <a:t>5/01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234F9-21FF-4935-A60D-E9940CAC81E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626369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DA66E-B52C-48E6-B222-2B34CF164A61}" type="datetimeFigureOut">
              <a:rPr lang="en-AU" smtClean="0"/>
              <a:t>5/01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234F9-21FF-4935-A60D-E9940CAC81E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741751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DA66E-B52C-48E6-B222-2B34CF164A61}" type="datetimeFigureOut">
              <a:rPr lang="en-AU" smtClean="0"/>
              <a:t>5/01/2022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234F9-21FF-4935-A60D-E9940CAC81E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57924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DA66E-B52C-48E6-B222-2B34CF164A61}" type="datetimeFigureOut">
              <a:rPr lang="en-AU" smtClean="0"/>
              <a:t>5/01/2022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234F9-21FF-4935-A60D-E9940CAC81E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574235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DA66E-B52C-48E6-B222-2B34CF164A61}" type="datetimeFigureOut">
              <a:rPr lang="en-AU" smtClean="0"/>
              <a:t>5/01/2022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234F9-21FF-4935-A60D-E9940CAC81E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922063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DA66E-B52C-48E6-B222-2B34CF164A61}" type="datetimeFigureOut">
              <a:rPr lang="en-AU" smtClean="0"/>
              <a:t>5/01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234F9-21FF-4935-A60D-E9940CAC81E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80014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EDA66E-B52C-48E6-B222-2B34CF164A61}" type="datetimeFigureOut">
              <a:rPr lang="en-AU" smtClean="0"/>
              <a:t>5/01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234F9-21FF-4935-A60D-E9940CAC81E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44260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EDA66E-B52C-48E6-B222-2B34CF164A61}" type="datetimeFigureOut">
              <a:rPr lang="en-AU" smtClean="0"/>
              <a:t>5/01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F234F9-21FF-4935-A60D-E9940CAC81E0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406526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3" Type="http://schemas.openxmlformats.org/officeDocument/2006/relationships/image" Target="../media/image4.png"/><Relationship Id="rId7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10" Type="http://schemas.openxmlformats.org/officeDocument/2006/relationships/image" Target="../media/image3.emf"/><Relationship Id="rId4" Type="http://schemas.openxmlformats.org/officeDocument/2006/relationships/image" Target="../media/image5.png"/><Relationship Id="rId9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2.emf"/><Relationship Id="rId5" Type="http://schemas.openxmlformats.org/officeDocument/2006/relationships/oleObject" Target="../embeddings/oleObject4.bin"/><Relationship Id="rId10" Type="http://schemas.openxmlformats.org/officeDocument/2006/relationships/image" Target="../media/image14.emf"/><Relationship Id="rId4" Type="http://schemas.openxmlformats.org/officeDocument/2006/relationships/image" Target="../media/image11.emf"/><Relationship Id="rId9" Type="http://schemas.openxmlformats.org/officeDocument/2006/relationships/oleObject" Target="../embeddings/oleObject6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15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16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3" Type="http://schemas.openxmlformats.org/officeDocument/2006/relationships/oleObject" Target="../embeddings/oleObject9.bin"/><Relationship Id="rId7" Type="http://schemas.openxmlformats.org/officeDocument/2006/relationships/oleObject" Target="../embeddings/oleObject11.bin"/><Relationship Id="rId12" Type="http://schemas.openxmlformats.org/officeDocument/2006/relationships/image" Target="../media/image21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18.emf"/><Relationship Id="rId11" Type="http://schemas.openxmlformats.org/officeDocument/2006/relationships/oleObject" Target="../embeddings/oleObject13.bin"/><Relationship Id="rId5" Type="http://schemas.openxmlformats.org/officeDocument/2006/relationships/oleObject" Target="../embeddings/oleObject10.bin"/><Relationship Id="rId10" Type="http://schemas.openxmlformats.org/officeDocument/2006/relationships/image" Target="../media/image20.emf"/><Relationship Id="rId4" Type="http://schemas.openxmlformats.org/officeDocument/2006/relationships/image" Target="../media/image17.emf"/><Relationship Id="rId9" Type="http://schemas.openxmlformats.org/officeDocument/2006/relationships/oleObject" Target="../embeddings/oleObject12.bin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6.vml"/><Relationship Id="rId4" Type="http://schemas.openxmlformats.org/officeDocument/2006/relationships/image" Target="../media/image22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5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7.vml"/><Relationship Id="rId4" Type="http://schemas.openxmlformats.org/officeDocument/2006/relationships/image" Target="../media/image2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2533139" y="439954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Figure 1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10575" y="1203496"/>
            <a:ext cx="3382506" cy="3085491"/>
          </a:xfrm>
          <a:prstGeom prst="rect">
            <a:avLst/>
          </a:prstGeom>
        </p:spPr>
      </p:pic>
      <p:graphicFrame>
        <p:nvGraphicFramePr>
          <p:cNvPr id="14" name="Table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1080534"/>
              </p:ext>
            </p:extLst>
          </p:nvPr>
        </p:nvGraphicFramePr>
        <p:xfrm>
          <a:off x="3606525" y="570949"/>
          <a:ext cx="2425700" cy="37492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20800">
                  <a:extLst>
                    <a:ext uri="{9D8B030D-6E8A-4147-A177-3AD203B41FA5}">
                      <a16:colId xmlns:a16="http://schemas.microsoft.com/office/drawing/2014/main" val="83715463"/>
                    </a:ext>
                  </a:extLst>
                </a:gridCol>
                <a:gridCol w="1104900">
                  <a:extLst>
                    <a:ext uri="{9D8B030D-6E8A-4147-A177-3AD203B41FA5}">
                      <a16:colId xmlns:a16="http://schemas.microsoft.com/office/drawing/2014/main" val="90045398"/>
                    </a:ext>
                  </a:extLst>
                </a:gridCol>
              </a:tblGrid>
              <a:tr h="383271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 dirty="0">
                          <a:effectLst/>
                        </a:rPr>
                        <a:t>Control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0.728882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850108014"/>
                  </a:ext>
                </a:extLst>
              </a:tr>
              <a:tr h="282016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Control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0.4527022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136021774"/>
                  </a:ext>
                </a:extLst>
              </a:tr>
              <a:tr h="282016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Control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0.3188047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650942346"/>
                  </a:ext>
                </a:extLst>
              </a:tr>
              <a:tr h="318404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09.585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504339285"/>
                  </a:ext>
                </a:extLst>
              </a:tr>
              <a:tr h="322953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20.2193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763162095"/>
                  </a:ext>
                </a:extLst>
              </a:tr>
              <a:tr h="304758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86.3176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905540587"/>
                  </a:ext>
                </a:extLst>
              </a:tr>
              <a:tr h="391182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.991032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198655834"/>
                  </a:ext>
                </a:extLst>
              </a:tr>
              <a:tr h="327502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8.986663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208425594"/>
                  </a:ext>
                </a:extLst>
              </a:tr>
              <a:tr h="33205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3.956522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692215394"/>
                  </a:ext>
                </a:extLst>
              </a:tr>
              <a:tr h="268369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Latent TGF-b1+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000" u="none" strike="noStrike">
                          <a:effectLst/>
                        </a:rPr>
                        <a:t>60.8507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247321370"/>
                  </a:ext>
                </a:extLst>
              </a:tr>
              <a:tr h="268369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Latent TGF-b1+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56.193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790018768"/>
                  </a:ext>
                </a:extLst>
              </a:tr>
              <a:tr h="268369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Latent TGF-b1+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 dirty="0">
                          <a:effectLst/>
                        </a:rPr>
                        <a:t>48.04011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2426490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784023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6455515" y="540025"/>
            <a:ext cx="1079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Figure 2D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8456946" y="572856"/>
            <a:ext cx="1079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Figure 2E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77614" y="4729005"/>
            <a:ext cx="1800384" cy="1624921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97612" y="4827346"/>
            <a:ext cx="1714279" cy="1526580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2603541" y="509195"/>
            <a:ext cx="1061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Figure 2B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63806" y="4788340"/>
            <a:ext cx="1871364" cy="1378369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10458377" y="540025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Figure 2F</a:t>
            </a: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331505" y="4875847"/>
            <a:ext cx="1528808" cy="1429578"/>
          </a:xfrm>
          <a:prstGeom prst="rect">
            <a:avLst/>
          </a:prstGeom>
        </p:spPr>
      </p:pic>
      <p:graphicFrame>
        <p:nvGraphicFramePr>
          <p:cNvPr id="20" name="Table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33252946"/>
              </p:ext>
            </p:extLst>
          </p:nvPr>
        </p:nvGraphicFramePr>
        <p:xfrm>
          <a:off x="2426834" y="993214"/>
          <a:ext cx="1714500" cy="3632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04900">
                  <a:extLst>
                    <a:ext uri="{9D8B030D-6E8A-4147-A177-3AD203B41FA5}">
                      <a16:colId xmlns:a16="http://schemas.microsoft.com/office/drawing/2014/main" val="3442332784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227974101"/>
                    </a:ext>
                  </a:extLst>
                </a:gridCol>
              </a:tblGrid>
              <a:tr h="187325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</a:rPr>
                        <a:t>Control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408488347"/>
                  </a:ext>
                </a:extLst>
              </a:tr>
              <a:tr h="187325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</a:rPr>
                        <a:t>Control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812967456"/>
                  </a:ext>
                </a:extLst>
              </a:tr>
              <a:tr h="187325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</a:rPr>
                        <a:t>Control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56239065"/>
                  </a:ext>
                </a:extLst>
              </a:tr>
              <a:tr h="187325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</a:rPr>
                        <a:t>Control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713141020"/>
                  </a:ext>
                </a:extLst>
              </a:tr>
              <a:tr h="187325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</a:rPr>
                        <a:t>Latent TGF-b1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 dirty="0">
                          <a:effectLst/>
                        </a:rPr>
                        <a:t>1.528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879340396"/>
                  </a:ext>
                </a:extLst>
              </a:tr>
              <a:tr h="187325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</a:rPr>
                        <a:t>Latent TGF-b1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 dirty="0">
                          <a:effectLst/>
                        </a:rPr>
                        <a:t>1.606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818359128"/>
                  </a:ext>
                </a:extLst>
              </a:tr>
              <a:tr h="187325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</a:rPr>
                        <a:t>Latent TGF-b1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 dirty="0">
                          <a:effectLst/>
                        </a:rPr>
                        <a:t>1.381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517774587"/>
                  </a:ext>
                </a:extLst>
              </a:tr>
              <a:tr h="187325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</a:rPr>
                        <a:t>Latent TGF-b1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 dirty="0">
                          <a:effectLst/>
                        </a:rPr>
                        <a:t>2.31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549247550"/>
                  </a:ext>
                </a:extLst>
              </a:tr>
              <a:tr h="187325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</a:rPr>
                        <a:t>PXS64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 dirty="0">
                          <a:effectLst/>
                        </a:rPr>
                        <a:t>0.881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802979566"/>
                  </a:ext>
                </a:extLst>
              </a:tr>
              <a:tr h="187325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</a:rPr>
                        <a:t>PXS64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 dirty="0">
                          <a:effectLst/>
                        </a:rPr>
                        <a:t>0.489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598072537"/>
                  </a:ext>
                </a:extLst>
              </a:tr>
              <a:tr h="187325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</a:rPr>
                        <a:t>PXS64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 dirty="0">
                          <a:effectLst/>
                        </a:rPr>
                        <a:t>0.891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668359275"/>
                  </a:ext>
                </a:extLst>
              </a:tr>
              <a:tr h="187325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</a:rPr>
                        <a:t>PXS64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 dirty="0">
                          <a:effectLst/>
                        </a:rPr>
                        <a:t>1.287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175167025"/>
                  </a:ext>
                </a:extLst>
              </a:tr>
              <a:tr h="3460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</a:rPr>
                        <a:t>Latent TGF-b1+PXS64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 dirty="0">
                          <a:effectLst/>
                        </a:rPr>
                        <a:t>0.946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451903975"/>
                  </a:ext>
                </a:extLst>
              </a:tr>
              <a:tr h="3460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</a:rPr>
                        <a:t>Latent TGF-b1+PXS64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 dirty="0">
                          <a:effectLst/>
                        </a:rPr>
                        <a:t>1.071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268925985"/>
                  </a:ext>
                </a:extLst>
              </a:tr>
              <a:tr h="3460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</a:rPr>
                        <a:t>Latent TGF-b1+PXS64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 dirty="0">
                          <a:effectLst/>
                        </a:rPr>
                        <a:t>0.648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370463302"/>
                  </a:ext>
                </a:extLst>
              </a:tr>
              <a:tr h="346075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</a:rPr>
                        <a:t>Latent TGF-b1+PXS64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 dirty="0">
                          <a:effectLst/>
                        </a:rPr>
                        <a:t>1.759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528476900"/>
                  </a:ext>
                </a:extLst>
              </a:tr>
            </a:tbl>
          </a:graphicData>
        </a:graphic>
      </p:graphicFrame>
      <p:graphicFrame>
        <p:nvGraphicFramePr>
          <p:cNvPr id="22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6202751"/>
              </p:ext>
            </p:extLst>
          </p:nvPr>
        </p:nvGraphicFramePr>
        <p:xfrm>
          <a:off x="6074312" y="984527"/>
          <a:ext cx="1676400" cy="371215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01700">
                  <a:extLst>
                    <a:ext uri="{9D8B030D-6E8A-4147-A177-3AD203B41FA5}">
                      <a16:colId xmlns:a16="http://schemas.microsoft.com/office/drawing/2014/main" val="3389588884"/>
                    </a:ext>
                  </a:extLst>
                </a:gridCol>
                <a:gridCol w="774700">
                  <a:extLst>
                    <a:ext uri="{9D8B030D-6E8A-4147-A177-3AD203B41FA5}">
                      <a16:colId xmlns:a16="http://schemas.microsoft.com/office/drawing/2014/main" val="2223525611"/>
                    </a:ext>
                  </a:extLst>
                </a:gridCol>
              </a:tblGrid>
              <a:tr h="281989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Control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0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331936295"/>
                  </a:ext>
                </a:extLst>
              </a:tr>
              <a:tr h="281989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Control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0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630955464"/>
                  </a:ext>
                </a:extLst>
              </a:tr>
              <a:tr h="281989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Control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0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137814622"/>
                  </a:ext>
                </a:extLst>
              </a:tr>
              <a:tr h="248319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228.0802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295232432"/>
                  </a:ext>
                </a:extLst>
              </a:tr>
              <a:tr h="248319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262.9545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146931803"/>
                  </a:ext>
                </a:extLst>
              </a:tr>
              <a:tr h="248319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209.2129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641354543"/>
                  </a:ext>
                </a:extLst>
              </a:tr>
              <a:tr h="248319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18.6145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4230718093"/>
                  </a:ext>
                </a:extLst>
              </a:tr>
              <a:tr h="248319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95.38048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233836771"/>
                  </a:ext>
                </a:extLst>
              </a:tr>
              <a:tr h="248319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02.7309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531128894"/>
                  </a:ext>
                </a:extLst>
              </a:tr>
              <a:tr h="458758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+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58.3372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808488207"/>
                  </a:ext>
                </a:extLst>
              </a:tr>
              <a:tr h="458758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+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77.9517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99400849"/>
                  </a:ext>
                </a:extLst>
              </a:tr>
              <a:tr h="458758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</a:rPr>
                        <a:t>Latent TGF-b1+PXS64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 dirty="0">
                          <a:effectLst/>
                        </a:rPr>
                        <a:t>172.3469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199243344"/>
                  </a:ext>
                </a:extLst>
              </a:tr>
            </a:tbl>
          </a:graphicData>
        </a:graphic>
      </p:graphicFrame>
      <p:graphicFrame>
        <p:nvGraphicFramePr>
          <p:cNvPr id="23" name="Table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71910386"/>
              </p:ext>
            </p:extLst>
          </p:nvPr>
        </p:nvGraphicFramePr>
        <p:xfrm>
          <a:off x="8139324" y="993216"/>
          <a:ext cx="1676400" cy="370346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01700">
                  <a:extLst>
                    <a:ext uri="{9D8B030D-6E8A-4147-A177-3AD203B41FA5}">
                      <a16:colId xmlns:a16="http://schemas.microsoft.com/office/drawing/2014/main" val="1256340000"/>
                    </a:ext>
                  </a:extLst>
                </a:gridCol>
                <a:gridCol w="774700">
                  <a:extLst>
                    <a:ext uri="{9D8B030D-6E8A-4147-A177-3AD203B41FA5}">
                      <a16:colId xmlns:a16="http://schemas.microsoft.com/office/drawing/2014/main" val="3586279574"/>
                    </a:ext>
                  </a:extLst>
                </a:gridCol>
              </a:tblGrid>
              <a:tr h="2648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Control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0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723879283"/>
                  </a:ext>
                </a:extLst>
              </a:tr>
              <a:tr h="2648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Control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0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766030309"/>
                  </a:ext>
                </a:extLst>
              </a:tr>
              <a:tr h="264838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Control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0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45954632"/>
                  </a:ext>
                </a:extLst>
              </a:tr>
              <a:tr h="252024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67.2538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357986559"/>
                  </a:ext>
                </a:extLst>
              </a:tr>
              <a:tr h="252024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28.9749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619999123"/>
                  </a:ext>
                </a:extLst>
              </a:tr>
              <a:tr h="252024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89.508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038451063"/>
                  </a:ext>
                </a:extLst>
              </a:tr>
              <a:tr h="252024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96.4828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326836430"/>
                  </a:ext>
                </a:extLst>
              </a:tr>
              <a:tr h="252024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17.063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683826125"/>
                  </a:ext>
                </a:extLst>
              </a:tr>
              <a:tr h="252024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46.229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91820045"/>
                  </a:ext>
                </a:extLst>
              </a:tr>
              <a:tr h="465602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+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03.3805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355722039"/>
                  </a:ext>
                </a:extLst>
              </a:tr>
              <a:tr h="465602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+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92.62282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459019121"/>
                  </a:ext>
                </a:extLst>
              </a:tr>
              <a:tr h="465602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+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 dirty="0">
                          <a:effectLst/>
                        </a:rPr>
                        <a:t>120.4957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408826568"/>
                  </a:ext>
                </a:extLst>
              </a:tr>
            </a:tbl>
          </a:graphicData>
        </a:graphic>
      </p:graphicFrame>
      <p:graphicFrame>
        <p:nvGraphicFramePr>
          <p:cNvPr id="24" name="Table 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31741649"/>
              </p:ext>
            </p:extLst>
          </p:nvPr>
        </p:nvGraphicFramePr>
        <p:xfrm>
          <a:off x="10141409" y="1063193"/>
          <a:ext cx="1676400" cy="366581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01700">
                  <a:extLst>
                    <a:ext uri="{9D8B030D-6E8A-4147-A177-3AD203B41FA5}">
                      <a16:colId xmlns:a16="http://schemas.microsoft.com/office/drawing/2014/main" val="3420346691"/>
                    </a:ext>
                  </a:extLst>
                </a:gridCol>
                <a:gridCol w="774700">
                  <a:extLst>
                    <a:ext uri="{9D8B030D-6E8A-4147-A177-3AD203B41FA5}">
                      <a16:colId xmlns:a16="http://schemas.microsoft.com/office/drawing/2014/main" val="367451894"/>
                    </a:ext>
                  </a:extLst>
                </a:gridCol>
              </a:tblGrid>
              <a:tr h="2621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Control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2.400558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718251400"/>
                  </a:ext>
                </a:extLst>
              </a:tr>
              <a:tr h="2621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Control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2.17216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303049421"/>
                  </a:ext>
                </a:extLst>
              </a:tr>
              <a:tr h="2621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Control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2.043778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538991539"/>
                  </a:ext>
                </a:extLst>
              </a:tr>
              <a:tr h="249461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4.118048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792873987"/>
                  </a:ext>
                </a:extLst>
              </a:tr>
              <a:tr h="249461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3.511085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089622856"/>
                  </a:ext>
                </a:extLst>
              </a:tr>
              <a:tr h="249461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4.209687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667395255"/>
                  </a:ext>
                </a:extLst>
              </a:tr>
              <a:tr h="249461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.11002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594377374"/>
                  </a:ext>
                </a:extLst>
              </a:tr>
              <a:tr h="249461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</a:rPr>
                        <a:t>PXS64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2.537652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586247017"/>
                  </a:ext>
                </a:extLst>
              </a:tr>
              <a:tr h="249461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2.92355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48343934"/>
                  </a:ext>
                </a:extLst>
              </a:tr>
              <a:tr h="460869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+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.368316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321256559"/>
                  </a:ext>
                </a:extLst>
              </a:tr>
              <a:tr h="460869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</a:rPr>
                        <a:t>Latent TGF-b1+PXS64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2.290412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042997160"/>
                  </a:ext>
                </a:extLst>
              </a:tr>
              <a:tr h="460869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 dirty="0">
                          <a:effectLst/>
                        </a:rPr>
                        <a:t>Latent TGF-b1+PXS64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 dirty="0">
                          <a:effectLst/>
                        </a:rPr>
                        <a:t>2.125311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618221477"/>
                  </a:ext>
                </a:extLst>
              </a:tr>
            </a:tbl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4478551"/>
              </p:ext>
            </p:extLst>
          </p:nvPr>
        </p:nvGraphicFramePr>
        <p:xfrm>
          <a:off x="331441" y="4729005"/>
          <a:ext cx="1612751" cy="14970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8" r:id="rId7" imgW="3563127" imgH="3307393" progId="Prism8.Document">
                  <p:embed/>
                </p:oleObj>
              </mc:Choice>
              <mc:Fallback>
                <p:oleObj name="Prism 8" r:id="rId7" imgW="3563127" imgH="330739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31441" y="4729005"/>
                        <a:ext cx="1612751" cy="14970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26753987"/>
              </p:ext>
            </p:extLst>
          </p:nvPr>
        </p:nvGraphicFramePr>
        <p:xfrm>
          <a:off x="285525" y="993214"/>
          <a:ext cx="1625500" cy="369492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25315">
                  <a:extLst>
                    <a:ext uri="{9D8B030D-6E8A-4147-A177-3AD203B41FA5}">
                      <a16:colId xmlns:a16="http://schemas.microsoft.com/office/drawing/2014/main" val="111059557"/>
                    </a:ext>
                  </a:extLst>
                </a:gridCol>
                <a:gridCol w="600185">
                  <a:extLst>
                    <a:ext uri="{9D8B030D-6E8A-4147-A177-3AD203B41FA5}">
                      <a16:colId xmlns:a16="http://schemas.microsoft.com/office/drawing/2014/main" val="1011368143"/>
                    </a:ext>
                  </a:extLst>
                </a:gridCol>
              </a:tblGrid>
              <a:tr h="161779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Control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26" marR="3126" marT="31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000" u="none" strike="noStrike">
                          <a:effectLst/>
                        </a:rPr>
                        <a:t>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126" marR="3126" marT="3126" marB="0" anchor="b"/>
                </a:tc>
                <a:extLst>
                  <a:ext uri="{0D108BD9-81ED-4DB2-BD59-A6C34878D82A}">
                    <a16:rowId xmlns:a16="http://schemas.microsoft.com/office/drawing/2014/main" val="532838882"/>
                  </a:ext>
                </a:extLst>
              </a:tr>
              <a:tr h="161779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Control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26" marR="3126" marT="31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000" u="none" strike="noStrike">
                          <a:effectLst/>
                        </a:rPr>
                        <a:t>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126" marR="3126" marT="3126" marB="0" anchor="b"/>
                </a:tc>
                <a:extLst>
                  <a:ext uri="{0D108BD9-81ED-4DB2-BD59-A6C34878D82A}">
                    <a16:rowId xmlns:a16="http://schemas.microsoft.com/office/drawing/2014/main" val="3765692828"/>
                  </a:ext>
                </a:extLst>
              </a:tr>
              <a:tr h="161779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Control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26" marR="3126" marT="31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000" u="none" strike="noStrike">
                          <a:effectLst/>
                        </a:rPr>
                        <a:t>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126" marR="3126" marT="3126" marB="0" anchor="b"/>
                </a:tc>
                <a:extLst>
                  <a:ext uri="{0D108BD9-81ED-4DB2-BD59-A6C34878D82A}">
                    <a16:rowId xmlns:a16="http://schemas.microsoft.com/office/drawing/2014/main" val="943491132"/>
                  </a:ext>
                </a:extLst>
              </a:tr>
              <a:tr h="161779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Control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26" marR="3126" marT="31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000" u="none" strike="noStrike">
                          <a:effectLst/>
                        </a:rPr>
                        <a:t>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126" marR="3126" marT="3126" marB="0" anchor="b"/>
                </a:tc>
                <a:extLst>
                  <a:ext uri="{0D108BD9-81ED-4DB2-BD59-A6C34878D82A}">
                    <a16:rowId xmlns:a16="http://schemas.microsoft.com/office/drawing/2014/main" val="3241326052"/>
                  </a:ext>
                </a:extLst>
              </a:tr>
              <a:tr h="2922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26" marR="3126" marT="31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000" u="none" strike="noStrike">
                          <a:effectLst/>
                        </a:rPr>
                        <a:t>2.278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126" marR="3126" marT="3126" marB="0" anchor="b"/>
                </a:tc>
                <a:extLst>
                  <a:ext uri="{0D108BD9-81ED-4DB2-BD59-A6C34878D82A}">
                    <a16:rowId xmlns:a16="http://schemas.microsoft.com/office/drawing/2014/main" val="2413944263"/>
                  </a:ext>
                </a:extLst>
              </a:tr>
              <a:tr h="2922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26" marR="3126" marT="31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000" u="none" strike="noStrike">
                          <a:effectLst/>
                        </a:rPr>
                        <a:t>1.528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126" marR="3126" marT="3126" marB="0" anchor="b"/>
                </a:tc>
                <a:extLst>
                  <a:ext uri="{0D108BD9-81ED-4DB2-BD59-A6C34878D82A}">
                    <a16:rowId xmlns:a16="http://schemas.microsoft.com/office/drawing/2014/main" val="98018002"/>
                  </a:ext>
                </a:extLst>
              </a:tr>
              <a:tr h="2922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26" marR="3126" marT="31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000" u="none" strike="noStrike">
                          <a:effectLst/>
                        </a:rPr>
                        <a:t>1.96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126" marR="3126" marT="3126" marB="0" anchor="b"/>
                </a:tc>
                <a:extLst>
                  <a:ext uri="{0D108BD9-81ED-4DB2-BD59-A6C34878D82A}">
                    <a16:rowId xmlns:a16="http://schemas.microsoft.com/office/drawing/2014/main" val="2149448372"/>
                  </a:ext>
                </a:extLst>
              </a:tr>
              <a:tr h="2922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26" marR="3126" marT="31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000" u="none" strike="noStrike">
                          <a:effectLst/>
                        </a:rPr>
                        <a:t>1.453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126" marR="3126" marT="3126" marB="0" anchor="b"/>
                </a:tc>
                <a:extLst>
                  <a:ext uri="{0D108BD9-81ED-4DB2-BD59-A6C34878D82A}">
                    <a16:rowId xmlns:a16="http://schemas.microsoft.com/office/drawing/2014/main" val="2899557281"/>
                  </a:ext>
                </a:extLst>
              </a:tr>
              <a:tr h="161779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26" marR="3126" marT="31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000" u="none" strike="noStrike">
                          <a:effectLst/>
                        </a:rPr>
                        <a:t>0.952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126" marR="3126" marT="3126" marB="0" anchor="b"/>
                </a:tc>
                <a:extLst>
                  <a:ext uri="{0D108BD9-81ED-4DB2-BD59-A6C34878D82A}">
                    <a16:rowId xmlns:a16="http://schemas.microsoft.com/office/drawing/2014/main" val="270497499"/>
                  </a:ext>
                </a:extLst>
              </a:tr>
              <a:tr h="161779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26" marR="3126" marT="31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000" u="none" strike="noStrike">
                          <a:effectLst/>
                        </a:rPr>
                        <a:t>0.88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126" marR="3126" marT="3126" marB="0" anchor="b"/>
                </a:tc>
                <a:extLst>
                  <a:ext uri="{0D108BD9-81ED-4DB2-BD59-A6C34878D82A}">
                    <a16:rowId xmlns:a16="http://schemas.microsoft.com/office/drawing/2014/main" val="1142363666"/>
                  </a:ext>
                </a:extLst>
              </a:tr>
              <a:tr h="161779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26" marR="3126" marT="31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000" u="none" strike="noStrike">
                          <a:effectLst/>
                        </a:rPr>
                        <a:t>0.979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126" marR="3126" marT="3126" marB="0" anchor="b"/>
                </a:tc>
                <a:extLst>
                  <a:ext uri="{0D108BD9-81ED-4DB2-BD59-A6C34878D82A}">
                    <a16:rowId xmlns:a16="http://schemas.microsoft.com/office/drawing/2014/main" val="2846837726"/>
                  </a:ext>
                </a:extLst>
              </a:tr>
              <a:tr h="161779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26" marR="3126" marT="31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000" u="none" strike="noStrike" dirty="0">
                          <a:effectLst/>
                        </a:rPr>
                        <a:t>0.509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126" marR="3126" marT="3126" marB="0" anchor="b"/>
                </a:tc>
                <a:extLst>
                  <a:ext uri="{0D108BD9-81ED-4DB2-BD59-A6C34878D82A}">
                    <a16:rowId xmlns:a16="http://schemas.microsoft.com/office/drawing/2014/main" val="33839771"/>
                  </a:ext>
                </a:extLst>
              </a:tr>
              <a:tr h="2922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+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26" marR="3126" marT="31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000" u="none" strike="noStrike">
                          <a:effectLst/>
                        </a:rPr>
                        <a:t>1.179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126" marR="3126" marT="3126" marB="0" anchor="b"/>
                </a:tc>
                <a:extLst>
                  <a:ext uri="{0D108BD9-81ED-4DB2-BD59-A6C34878D82A}">
                    <a16:rowId xmlns:a16="http://schemas.microsoft.com/office/drawing/2014/main" val="3368587912"/>
                  </a:ext>
                </a:extLst>
              </a:tr>
              <a:tr h="2922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+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26" marR="3126" marT="31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000" u="none" strike="noStrike">
                          <a:effectLst/>
                        </a:rPr>
                        <a:t>0.946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126" marR="3126" marT="3126" marB="0" anchor="b"/>
                </a:tc>
                <a:extLst>
                  <a:ext uri="{0D108BD9-81ED-4DB2-BD59-A6C34878D82A}">
                    <a16:rowId xmlns:a16="http://schemas.microsoft.com/office/drawing/2014/main" val="3128884837"/>
                  </a:ext>
                </a:extLst>
              </a:tr>
              <a:tr h="2922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+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26" marR="3126" marT="31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000" u="none" strike="noStrike">
                          <a:effectLst/>
                        </a:rPr>
                        <a:t>1.227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126" marR="3126" marT="3126" marB="0" anchor="b"/>
                </a:tc>
                <a:extLst>
                  <a:ext uri="{0D108BD9-81ED-4DB2-BD59-A6C34878D82A}">
                    <a16:rowId xmlns:a16="http://schemas.microsoft.com/office/drawing/2014/main" val="2145261414"/>
                  </a:ext>
                </a:extLst>
              </a:tr>
              <a:tr h="292246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1000" u="none" strike="noStrike">
                          <a:effectLst/>
                        </a:rPr>
                        <a:t>Latent TGF-b1+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26" marR="3126" marT="31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000" u="none" strike="noStrike" dirty="0">
                          <a:effectLst/>
                        </a:rPr>
                        <a:t>0.556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126" marR="3126" marT="3126" marB="0" anchor="b"/>
                </a:tc>
                <a:extLst>
                  <a:ext uri="{0D108BD9-81ED-4DB2-BD59-A6C34878D82A}">
                    <a16:rowId xmlns:a16="http://schemas.microsoft.com/office/drawing/2014/main" val="289276122"/>
                  </a:ext>
                </a:extLst>
              </a:tr>
            </a:tbl>
          </a:graphicData>
        </a:graphic>
      </p:graphicFrame>
      <p:sp>
        <p:nvSpPr>
          <p:cNvPr id="21" name="TextBox 20"/>
          <p:cNvSpPr txBox="1"/>
          <p:nvPr/>
        </p:nvSpPr>
        <p:spPr>
          <a:xfrm>
            <a:off x="529626" y="540025"/>
            <a:ext cx="1061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Figure 2A</a:t>
            </a: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4813"/>
              </p:ext>
            </p:extLst>
          </p:nvPr>
        </p:nvGraphicFramePr>
        <p:xfrm>
          <a:off x="4476919" y="4729004"/>
          <a:ext cx="1613207" cy="14974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8" r:id="rId9" imgW="3563127" imgH="3307393" progId="Prism8.Document">
                  <p:embed/>
                </p:oleObj>
              </mc:Choice>
              <mc:Fallback>
                <p:oleObj name="Prism 8" r:id="rId9" imgW="3563127" imgH="330739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476919" y="4729004"/>
                        <a:ext cx="1613207" cy="14974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10939668"/>
              </p:ext>
            </p:extLst>
          </p:nvPr>
        </p:nvGraphicFramePr>
        <p:xfrm>
          <a:off x="4577253" y="984525"/>
          <a:ext cx="1149184" cy="371215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4592">
                  <a:extLst>
                    <a:ext uri="{9D8B030D-6E8A-4147-A177-3AD203B41FA5}">
                      <a16:colId xmlns:a16="http://schemas.microsoft.com/office/drawing/2014/main" val="2753235166"/>
                    </a:ext>
                  </a:extLst>
                </a:gridCol>
                <a:gridCol w="574592">
                  <a:extLst>
                    <a:ext uri="{9D8B030D-6E8A-4147-A177-3AD203B41FA5}">
                      <a16:colId xmlns:a16="http://schemas.microsoft.com/office/drawing/2014/main" val="3776597476"/>
                    </a:ext>
                  </a:extLst>
                </a:gridCol>
              </a:tblGrid>
              <a:tr h="158435">
                <a:tc>
                  <a:txBody>
                    <a:bodyPr/>
                    <a:lstStyle/>
                    <a:p>
                      <a:pPr algn="l" fontAlgn="b"/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93" marR="2993" marT="299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MCP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93" marR="2993" marT="2993" marB="0" anchor="b"/>
                </a:tc>
                <a:extLst>
                  <a:ext uri="{0D108BD9-81ED-4DB2-BD59-A6C34878D82A}">
                    <a16:rowId xmlns:a16="http://schemas.microsoft.com/office/drawing/2014/main" val="1925904191"/>
                  </a:ext>
                </a:extLst>
              </a:tr>
              <a:tr h="158284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Control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93" marR="2993" marT="29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93" marR="2993" marT="2993" marB="0" anchor="b"/>
                </a:tc>
                <a:extLst>
                  <a:ext uri="{0D108BD9-81ED-4DB2-BD59-A6C34878D82A}">
                    <a16:rowId xmlns:a16="http://schemas.microsoft.com/office/drawing/2014/main" val="3824752489"/>
                  </a:ext>
                </a:extLst>
              </a:tr>
              <a:tr h="158284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Control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93" marR="2993" marT="29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93" marR="2993" marT="2993" marB="0" anchor="b"/>
                </a:tc>
                <a:extLst>
                  <a:ext uri="{0D108BD9-81ED-4DB2-BD59-A6C34878D82A}">
                    <a16:rowId xmlns:a16="http://schemas.microsoft.com/office/drawing/2014/main" val="4243160722"/>
                  </a:ext>
                </a:extLst>
              </a:tr>
              <a:tr h="158284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Control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93" marR="2993" marT="29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93" marR="2993" marT="2993" marB="0" anchor="b"/>
                </a:tc>
                <a:extLst>
                  <a:ext uri="{0D108BD9-81ED-4DB2-BD59-A6C34878D82A}">
                    <a16:rowId xmlns:a16="http://schemas.microsoft.com/office/drawing/2014/main" val="3062149902"/>
                  </a:ext>
                </a:extLst>
              </a:tr>
              <a:tr h="158284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Control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93" marR="2993" marT="29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93" marR="2993" marT="2993" marB="0" anchor="b"/>
                </a:tc>
                <a:extLst>
                  <a:ext uri="{0D108BD9-81ED-4DB2-BD59-A6C34878D82A}">
                    <a16:rowId xmlns:a16="http://schemas.microsoft.com/office/drawing/2014/main" val="2635149213"/>
                  </a:ext>
                </a:extLst>
              </a:tr>
              <a:tr h="285931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Latent TGF-b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93" marR="2993" marT="29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45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93" marR="2993" marT="2993" marB="0" anchor="b"/>
                </a:tc>
                <a:extLst>
                  <a:ext uri="{0D108BD9-81ED-4DB2-BD59-A6C34878D82A}">
                    <a16:rowId xmlns:a16="http://schemas.microsoft.com/office/drawing/2014/main" val="2419163967"/>
                  </a:ext>
                </a:extLst>
              </a:tr>
              <a:tr h="285931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Latent TGF-b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93" marR="2993" marT="29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796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93" marR="2993" marT="2993" marB="0" anchor="b"/>
                </a:tc>
                <a:extLst>
                  <a:ext uri="{0D108BD9-81ED-4DB2-BD59-A6C34878D82A}">
                    <a16:rowId xmlns:a16="http://schemas.microsoft.com/office/drawing/2014/main" val="1683339829"/>
                  </a:ext>
                </a:extLst>
              </a:tr>
              <a:tr h="285931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Latent TGF-b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93" marR="2993" marT="29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25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93" marR="2993" marT="2993" marB="0" anchor="b"/>
                </a:tc>
                <a:extLst>
                  <a:ext uri="{0D108BD9-81ED-4DB2-BD59-A6C34878D82A}">
                    <a16:rowId xmlns:a16="http://schemas.microsoft.com/office/drawing/2014/main" val="2122546842"/>
                  </a:ext>
                </a:extLst>
              </a:tr>
              <a:tr h="285931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Latent TGF-b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93" marR="2993" marT="29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3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93" marR="2993" marT="2993" marB="0" anchor="b"/>
                </a:tc>
                <a:extLst>
                  <a:ext uri="{0D108BD9-81ED-4DB2-BD59-A6C34878D82A}">
                    <a16:rowId xmlns:a16="http://schemas.microsoft.com/office/drawing/2014/main" val="801632154"/>
                  </a:ext>
                </a:extLst>
              </a:tr>
              <a:tr h="158284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PXS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93" marR="2993" marT="29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50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93" marR="2993" marT="2993" marB="0" anchor="b"/>
                </a:tc>
                <a:extLst>
                  <a:ext uri="{0D108BD9-81ED-4DB2-BD59-A6C34878D82A}">
                    <a16:rowId xmlns:a16="http://schemas.microsoft.com/office/drawing/2014/main" val="3989843905"/>
                  </a:ext>
                </a:extLst>
              </a:tr>
              <a:tr h="158284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PXS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93" marR="2993" marT="29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3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93" marR="2993" marT="2993" marB="0" anchor="b"/>
                </a:tc>
                <a:extLst>
                  <a:ext uri="{0D108BD9-81ED-4DB2-BD59-A6C34878D82A}">
                    <a16:rowId xmlns:a16="http://schemas.microsoft.com/office/drawing/2014/main" val="2642242248"/>
                  </a:ext>
                </a:extLst>
              </a:tr>
              <a:tr h="158284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PXS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93" marR="2993" marT="29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97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93" marR="2993" marT="2993" marB="0" anchor="b"/>
                </a:tc>
                <a:extLst>
                  <a:ext uri="{0D108BD9-81ED-4DB2-BD59-A6C34878D82A}">
                    <a16:rowId xmlns:a16="http://schemas.microsoft.com/office/drawing/2014/main" val="1360739014"/>
                  </a:ext>
                </a:extLst>
              </a:tr>
              <a:tr h="158284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PXS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93" marR="2993" marT="29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50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93" marR="2993" marT="2993" marB="0" anchor="b"/>
                </a:tc>
                <a:extLst>
                  <a:ext uri="{0D108BD9-81ED-4DB2-BD59-A6C34878D82A}">
                    <a16:rowId xmlns:a16="http://schemas.microsoft.com/office/drawing/2014/main" val="2408030344"/>
                  </a:ext>
                </a:extLst>
              </a:tr>
              <a:tr h="285931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Latent TGF-b1+PXS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93" marR="2993" marT="29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556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93" marR="2993" marT="2993" marB="0" anchor="b"/>
                </a:tc>
                <a:extLst>
                  <a:ext uri="{0D108BD9-81ED-4DB2-BD59-A6C34878D82A}">
                    <a16:rowId xmlns:a16="http://schemas.microsoft.com/office/drawing/2014/main" val="3287083407"/>
                  </a:ext>
                </a:extLst>
              </a:tr>
              <a:tr h="285931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Latent TGF-b1+PXS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93" marR="2993" marT="29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906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93" marR="2993" marT="2993" marB="0" anchor="b"/>
                </a:tc>
                <a:extLst>
                  <a:ext uri="{0D108BD9-81ED-4DB2-BD59-A6C34878D82A}">
                    <a16:rowId xmlns:a16="http://schemas.microsoft.com/office/drawing/2014/main" val="1152200372"/>
                  </a:ext>
                </a:extLst>
              </a:tr>
              <a:tr h="285931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Latent TGF-b1+PXS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93" marR="2993" marT="29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126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93" marR="2993" marT="2993" marB="0" anchor="b"/>
                </a:tc>
                <a:extLst>
                  <a:ext uri="{0D108BD9-81ED-4DB2-BD59-A6C34878D82A}">
                    <a16:rowId xmlns:a16="http://schemas.microsoft.com/office/drawing/2014/main" val="2415110573"/>
                  </a:ext>
                </a:extLst>
              </a:tr>
              <a:tr h="285931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Latent TGF-b1+PXS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993" marR="2993" marT="299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 dirty="0">
                          <a:effectLst/>
                        </a:rPr>
                        <a:t>0.556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993" marR="2993" marT="2993" marB="0" anchor="b"/>
                </a:tc>
                <a:extLst>
                  <a:ext uri="{0D108BD9-81ED-4DB2-BD59-A6C34878D82A}">
                    <a16:rowId xmlns:a16="http://schemas.microsoft.com/office/drawing/2014/main" val="3369516085"/>
                  </a:ext>
                </a:extLst>
              </a:tr>
            </a:tbl>
          </a:graphicData>
        </a:graphic>
      </p:graphicFrame>
      <p:sp>
        <p:nvSpPr>
          <p:cNvPr id="25" name="TextBox 24"/>
          <p:cNvSpPr txBox="1"/>
          <p:nvPr/>
        </p:nvSpPr>
        <p:spPr>
          <a:xfrm>
            <a:off x="4617599" y="540025"/>
            <a:ext cx="1060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/>
              <a:t>Figure 2C</a:t>
            </a:r>
          </a:p>
        </p:txBody>
      </p:sp>
    </p:spTree>
    <p:extLst>
      <p:ext uri="{BB962C8B-B14F-4D97-AF65-F5344CB8AC3E}">
        <p14:creationId xmlns:p14="http://schemas.microsoft.com/office/powerpoint/2010/main" val="24622008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8799217" y="357606"/>
            <a:ext cx="1060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Figure 3C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584314" y="357606"/>
            <a:ext cx="10733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Figure 3B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945777" y="338477"/>
            <a:ext cx="10733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Figure 3A</a:t>
            </a:r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38652" y="4849877"/>
            <a:ext cx="2145587" cy="1663393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71557" y="4823764"/>
            <a:ext cx="1949834" cy="1885143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26226" y="4827421"/>
            <a:ext cx="2286157" cy="1881486"/>
          </a:xfrm>
          <a:prstGeom prst="rect">
            <a:avLst/>
          </a:prstGeom>
        </p:spPr>
      </p:pic>
      <p:graphicFrame>
        <p:nvGraphicFramePr>
          <p:cNvPr id="28" name="Table 2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88856513"/>
              </p:ext>
            </p:extLst>
          </p:nvPr>
        </p:nvGraphicFramePr>
        <p:xfrm>
          <a:off x="2675263" y="825909"/>
          <a:ext cx="1614400" cy="381030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79045">
                  <a:extLst>
                    <a:ext uri="{9D8B030D-6E8A-4147-A177-3AD203B41FA5}">
                      <a16:colId xmlns:a16="http://schemas.microsoft.com/office/drawing/2014/main" val="1664323836"/>
                    </a:ext>
                  </a:extLst>
                </a:gridCol>
                <a:gridCol w="735355">
                  <a:extLst>
                    <a:ext uri="{9D8B030D-6E8A-4147-A177-3AD203B41FA5}">
                      <a16:colId xmlns:a16="http://schemas.microsoft.com/office/drawing/2014/main" val="2405565817"/>
                    </a:ext>
                  </a:extLst>
                </a:gridCol>
              </a:tblGrid>
              <a:tr h="225815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Control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 dirty="0">
                          <a:effectLst/>
                        </a:rPr>
                        <a:t>100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859774361"/>
                  </a:ext>
                </a:extLst>
              </a:tr>
              <a:tr h="260233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Control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0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500637692"/>
                  </a:ext>
                </a:extLst>
              </a:tr>
              <a:tr h="260233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Control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0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90215840"/>
                  </a:ext>
                </a:extLst>
              </a:tr>
              <a:tr h="29381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405.706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792105357"/>
                  </a:ext>
                </a:extLst>
              </a:tr>
              <a:tr h="298007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2993.93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951351816"/>
                  </a:ext>
                </a:extLst>
              </a:tr>
              <a:tr h="281218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2244.38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435975175"/>
                  </a:ext>
                </a:extLst>
              </a:tr>
              <a:tr h="360967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16.161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050268020"/>
                  </a:ext>
                </a:extLst>
              </a:tr>
              <a:tr h="302205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 dirty="0">
                          <a:effectLst/>
                        </a:rPr>
                        <a:t>8.973652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516063155"/>
                  </a:ext>
                </a:extLst>
              </a:tr>
              <a:tr h="306402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65.17619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807356026"/>
                  </a:ext>
                </a:extLst>
              </a:tr>
              <a:tr h="407138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Latent TGF-b1+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533.0338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640142005"/>
                  </a:ext>
                </a:extLst>
              </a:tr>
              <a:tr h="407138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Latent TGF-b1+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234.656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647016636"/>
                  </a:ext>
                </a:extLst>
              </a:tr>
              <a:tr h="407138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 dirty="0">
                          <a:effectLst/>
                        </a:rPr>
                        <a:t>Latent TGF-b1+PXS64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 dirty="0">
                          <a:effectLst/>
                        </a:rPr>
                        <a:t>1303.119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637155910"/>
                  </a:ext>
                </a:extLst>
              </a:tr>
            </a:tbl>
          </a:graphicData>
        </a:graphic>
      </p:graphicFrame>
      <p:graphicFrame>
        <p:nvGraphicFramePr>
          <p:cNvPr id="29" name="Table 2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22703173"/>
              </p:ext>
            </p:extLst>
          </p:nvPr>
        </p:nvGraphicFramePr>
        <p:xfrm>
          <a:off x="5420876" y="873103"/>
          <a:ext cx="1615450" cy="380465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79617">
                  <a:extLst>
                    <a:ext uri="{9D8B030D-6E8A-4147-A177-3AD203B41FA5}">
                      <a16:colId xmlns:a16="http://schemas.microsoft.com/office/drawing/2014/main" val="395992571"/>
                    </a:ext>
                  </a:extLst>
                </a:gridCol>
                <a:gridCol w="735833">
                  <a:extLst>
                    <a:ext uri="{9D8B030D-6E8A-4147-A177-3AD203B41FA5}">
                      <a16:colId xmlns:a16="http://schemas.microsoft.com/office/drawing/2014/main" val="807734324"/>
                    </a:ext>
                  </a:extLst>
                </a:gridCol>
              </a:tblGrid>
              <a:tr h="269273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Control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0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960637715"/>
                  </a:ext>
                </a:extLst>
              </a:tr>
              <a:tr h="269273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Control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0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953688751"/>
                  </a:ext>
                </a:extLst>
              </a:tr>
              <a:tr h="269273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Control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0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401561464"/>
                  </a:ext>
                </a:extLst>
              </a:tr>
              <a:tr h="304017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7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059267840"/>
                  </a:ext>
                </a:extLst>
              </a:tr>
              <a:tr h="30836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46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349117586"/>
                  </a:ext>
                </a:extLst>
              </a:tr>
              <a:tr h="290988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37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804742717"/>
                  </a:ext>
                </a:extLst>
              </a:tr>
              <a:tr h="373507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02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55913459"/>
                  </a:ext>
                </a:extLst>
              </a:tr>
              <a:tr h="312703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86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696179712"/>
                  </a:ext>
                </a:extLst>
              </a:tr>
              <a:tr h="317047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4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722694993"/>
                  </a:ext>
                </a:extLst>
              </a:tr>
              <a:tr h="363403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Latent TGF-b1+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36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973835664"/>
                  </a:ext>
                </a:extLst>
              </a:tr>
              <a:tr h="363403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Latent TGF-b1+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03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820863555"/>
                  </a:ext>
                </a:extLst>
              </a:tr>
              <a:tr h="363403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Latent TGF-b1+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 dirty="0">
                          <a:effectLst/>
                        </a:rPr>
                        <a:t>135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866542420"/>
                  </a:ext>
                </a:extLst>
              </a:tr>
            </a:tbl>
          </a:graphicData>
        </a:graphic>
      </p:graphicFrame>
      <p:graphicFrame>
        <p:nvGraphicFramePr>
          <p:cNvPr id="30" name="Table 2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67221939"/>
              </p:ext>
            </p:extLst>
          </p:nvPr>
        </p:nvGraphicFramePr>
        <p:xfrm>
          <a:off x="8623179" y="914400"/>
          <a:ext cx="1694295" cy="376335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22548">
                  <a:extLst>
                    <a:ext uri="{9D8B030D-6E8A-4147-A177-3AD203B41FA5}">
                      <a16:colId xmlns:a16="http://schemas.microsoft.com/office/drawing/2014/main" val="2506760533"/>
                    </a:ext>
                  </a:extLst>
                </a:gridCol>
                <a:gridCol w="771747">
                  <a:extLst>
                    <a:ext uri="{9D8B030D-6E8A-4147-A177-3AD203B41FA5}">
                      <a16:colId xmlns:a16="http://schemas.microsoft.com/office/drawing/2014/main" val="2812006005"/>
                    </a:ext>
                  </a:extLst>
                </a:gridCol>
              </a:tblGrid>
              <a:tr h="254725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Control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0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954373595"/>
                  </a:ext>
                </a:extLst>
              </a:tr>
              <a:tr h="254725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Control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0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211586844"/>
                  </a:ext>
                </a:extLst>
              </a:tr>
              <a:tr h="254725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Control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00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56302272"/>
                  </a:ext>
                </a:extLst>
              </a:tr>
              <a:tr h="287592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43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65270903"/>
                  </a:ext>
                </a:extLst>
              </a:tr>
              <a:tr h="29170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Latent TGF-b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68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932223599"/>
                  </a:ext>
                </a:extLst>
              </a:tr>
              <a:tr h="275268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 dirty="0">
                          <a:effectLst/>
                        </a:rPr>
                        <a:t>Latent TGF-b1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47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262019647"/>
                  </a:ext>
                </a:extLst>
              </a:tr>
              <a:tr h="353328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07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725941718"/>
                  </a:ext>
                </a:extLst>
              </a:tr>
              <a:tr h="295810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02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140850901"/>
                  </a:ext>
                </a:extLst>
              </a:tr>
              <a:tr h="299918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22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286036265"/>
                  </a:ext>
                </a:extLst>
              </a:tr>
              <a:tr h="39852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Latent TGF-b1+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35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024412441"/>
                  </a:ext>
                </a:extLst>
              </a:tr>
              <a:tr h="39852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Latent TGF-b1+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137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150402889"/>
                  </a:ext>
                </a:extLst>
              </a:tr>
              <a:tr h="39852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Latent TGF-b1+PXS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 dirty="0">
                          <a:effectLst/>
                        </a:rPr>
                        <a:t>84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07679357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843375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1596854" y="314549"/>
            <a:ext cx="113588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Figure 5 A</a:t>
            </a:r>
          </a:p>
          <a:p>
            <a:endParaRPr lang="en-AU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3817708" y="287108"/>
            <a:ext cx="113588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Figure 5 B</a:t>
            </a:r>
          </a:p>
          <a:p>
            <a:endParaRPr lang="en-AU" b="1" dirty="0"/>
          </a:p>
        </p:txBody>
      </p:sp>
      <p:graphicFrame>
        <p:nvGraphicFramePr>
          <p:cNvPr id="16" name="Table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85636874"/>
              </p:ext>
            </p:extLst>
          </p:nvPr>
        </p:nvGraphicFramePr>
        <p:xfrm>
          <a:off x="7052173" y="766317"/>
          <a:ext cx="1229728" cy="436729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1486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1486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7295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sha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10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295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sha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138.394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295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sha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10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7295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sha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123.268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7295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tro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349.789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7295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tro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210.032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7295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tro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384.570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7295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ontrol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440.189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7295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elmi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86.2833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7295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elmi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90.3429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7295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elmi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40.9061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7295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elmi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74.2079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7295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PSX6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35.4971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7295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PSX6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56.5934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7295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PSX6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110.881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7295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PSX6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47.2524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</a:tbl>
          </a:graphicData>
        </a:graphic>
      </p:graphicFrame>
      <p:sp>
        <p:nvSpPr>
          <p:cNvPr id="17" name="TextBox 16"/>
          <p:cNvSpPr txBox="1"/>
          <p:nvPr/>
        </p:nvSpPr>
        <p:spPr>
          <a:xfrm>
            <a:off x="7254284" y="450075"/>
            <a:ext cx="745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Fig 5C</a:t>
            </a:r>
          </a:p>
        </p:txBody>
      </p:sp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13184922"/>
              </p:ext>
            </p:extLst>
          </p:nvPr>
        </p:nvGraphicFramePr>
        <p:xfrm>
          <a:off x="6829206" y="5152256"/>
          <a:ext cx="1602126" cy="13201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Prism 8" r:id="rId3" imgW="3863354" imgH="2501247" progId="Prism8.Document">
                  <p:embed/>
                </p:oleObj>
              </mc:Choice>
              <mc:Fallback>
                <p:oleObj name="Prism 8" r:id="rId3" imgW="3863354" imgH="2501247" progId="Prism8.Document">
                  <p:embed/>
                  <p:pic>
                    <p:nvPicPr>
                      <p:cNvPr id="18" name="Object 17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829206" y="5152256"/>
                        <a:ext cx="1602126" cy="13201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18"/>
          <p:cNvSpPr txBox="1"/>
          <p:nvPr/>
        </p:nvSpPr>
        <p:spPr>
          <a:xfrm>
            <a:off x="9160857" y="434417"/>
            <a:ext cx="7649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Fig 5D</a:t>
            </a:r>
          </a:p>
        </p:txBody>
      </p:sp>
      <p:graphicFrame>
        <p:nvGraphicFramePr>
          <p:cNvPr id="22" name="Objec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51914131"/>
              </p:ext>
            </p:extLst>
          </p:nvPr>
        </p:nvGraphicFramePr>
        <p:xfrm>
          <a:off x="8914097" y="5086461"/>
          <a:ext cx="1585239" cy="14517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8" r:id="rId5" imgW="3820516" imgH="2501247" progId="Prism8.Document">
                  <p:embed/>
                </p:oleObj>
              </mc:Choice>
              <mc:Fallback>
                <p:oleObj name="Prism 8" r:id="rId5" imgW="3820516" imgH="2501247" progId="Prism8.Document">
                  <p:embed/>
                  <p:pic>
                    <p:nvPicPr>
                      <p:cNvPr id="22" name="Object 2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914097" y="5086461"/>
                        <a:ext cx="1585239" cy="14517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Table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36865311"/>
              </p:ext>
            </p:extLst>
          </p:nvPr>
        </p:nvGraphicFramePr>
        <p:xfrm>
          <a:off x="8947672" y="765149"/>
          <a:ext cx="1456304" cy="438710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44484">
                  <a:extLst>
                    <a:ext uri="{9D8B030D-6E8A-4147-A177-3AD203B41FA5}">
                      <a16:colId xmlns:a16="http://schemas.microsoft.com/office/drawing/2014/main" val="4098348744"/>
                    </a:ext>
                  </a:extLst>
                </a:gridCol>
                <a:gridCol w="611820">
                  <a:extLst>
                    <a:ext uri="{9D8B030D-6E8A-4147-A177-3AD203B41FA5}">
                      <a16:colId xmlns:a16="http://schemas.microsoft.com/office/drawing/2014/main" val="3291164166"/>
                    </a:ext>
                  </a:extLst>
                </a:gridCol>
              </a:tblGrid>
              <a:tr h="24703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Sham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0.226919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extLst>
                  <a:ext uri="{0D108BD9-81ED-4DB2-BD59-A6C34878D82A}">
                    <a16:rowId xmlns:a16="http://schemas.microsoft.com/office/drawing/2014/main" val="3793034664"/>
                  </a:ext>
                </a:extLst>
              </a:tr>
              <a:tr h="297660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 dirty="0">
                          <a:effectLst/>
                        </a:rPr>
                        <a:t>Sham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0.286217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extLst>
                  <a:ext uri="{0D108BD9-81ED-4DB2-BD59-A6C34878D82A}">
                    <a16:rowId xmlns:a16="http://schemas.microsoft.com/office/drawing/2014/main" val="1041080898"/>
                  </a:ext>
                </a:extLst>
              </a:tr>
              <a:tr h="297660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 dirty="0">
                          <a:effectLst/>
                        </a:rPr>
                        <a:t>Sham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0.169869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extLst>
                  <a:ext uri="{0D108BD9-81ED-4DB2-BD59-A6C34878D82A}">
                    <a16:rowId xmlns:a16="http://schemas.microsoft.com/office/drawing/2014/main" val="3218611791"/>
                  </a:ext>
                </a:extLst>
              </a:tr>
              <a:tr h="297660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Sham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0.190263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extLst>
                  <a:ext uri="{0D108BD9-81ED-4DB2-BD59-A6C34878D82A}">
                    <a16:rowId xmlns:a16="http://schemas.microsoft.com/office/drawing/2014/main" val="2059756036"/>
                  </a:ext>
                </a:extLst>
              </a:tr>
              <a:tr h="288455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100" u="none" strike="noStrike">
                          <a:effectLst/>
                        </a:rPr>
                        <a:t>UUO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0.714407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extLst>
                  <a:ext uri="{0D108BD9-81ED-4DB2-BD59-A6C34878D82A}">
                    <a16:rowId xmlns:a16="http://schemas.microsoft.com/office/drawing/2014/main" val="4219899708"/>
                  </a:ext>
                </a:extLst>
              </a:tr>
              <a:tr h="288455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100" u="none" strike="noStrike">
                          <a:effectLst/>
                        </a:rPr>
                        <a:t>UUO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0.58310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extLst>
                  <a:ext uri="{0D108BD9-81ED-4DB2-BD59-A6C34878D82A}">
                    <a16:rowId xmlns:a16="http://schemas.microsoft.com/office/drawing/2014/main" val="65371285"/>
                  </a:ext>
                </a:extLst>
              </a:tr>
              <a:tr h="288455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100" u="none" strike="noStrike">
                          <a:effectLst/>
                        </a:rPr>
                        <a:t>UUO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0.671486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extLst>
                  <a:ext uri="{0D108BD9-81ED-4DB2-BD59-A6C34878D82A}">
                    <a16:rowId xmlns:a16="http://schemas.microsoft.com/office/drawing/2014/main" val="1467754596"/>
                  </a:ext>
                </a:extLst>
              </a:tr>
              <a:tr h="288455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100" u="none" strike="noStrike">
                          <a:effectLst/>
                        </a:rPr>
                        <a:t>UUO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0.788865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extLst>
                  <a:ext uri="{0D108BD9-81ED-4DB2-BD59-A6C34878D82A}">
                    <a16:rowId xmlns:a16="http://schemas.microsoft.com/office/drawing/2014/main" val="1869109595"/>
                  </a:ext>
                </a:extLst>
              </a:tr>
              <a:tr h="288455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100" u="none" strike="noStrike" dirty="0" err="1">
                          <a:effectLst/>
                        </a:rPr>
                        <a:t>Telmi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0.38840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extLst>
                  <a:ext uri="{0D108BD9-81ED-4DB2-BD59-A6C34878D82A}">
                    <a16:rowId xmlns:a16="http://schemas.microsoft.com/office/drawing/2014/main" val="1922123089"/>
                  </a:ext>
                </a:extLst>
              </a:tr>
              <a:tr h="288455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100" u="none" strike="noStrike" dirty="0" err="1">
                          <a:effectLst/>
                        </a:rPr>
                        <a:t>Telmi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0.399158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extLst>
                  <a:ext uri="{0D108BD9-81ED-4DB2-BD59-A6C34878D82A}">
                    <a16:rowId xmlns:a16="http://schemas.microsoft.com/office/drawing/2014/main" val="870111053"/>
                  </a:ext>
                </a:extLst>
              </a:tr>
              <a:tr h="288455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100" u="none" strike="noStrike">
                          <a:effectLst/>
                        </a:rPr>
                        <a:t>Telmi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0.681996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extLst>
                  <a:ext uri="{0D108BD9-81ED-4DB2-BD59-A6C34878D82A}">
                    <a16:rowId xmlns:a16="http://schemas.microsoft.com/office/drawing/2014/main" val="2539023912"/>
                  </a:ext>
                </a:extLst>
              </a:tr>
              <a:tr h="234974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100" u="none" strike="noStrike">
                          <a:effectLst/>
                        </a:rPr>
                        <a:t>Telmi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0.482619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extLst>
                  <a:ext uri="{0D108BD9-81ED-4DB2-BD59-A6C34878D82A}">
                    <a16:rowId xmlns:a16="http://schemas.microsoft.com/office/drawing/2014/main" val="3883154244"/>
                  </a:ext>
                </a:extLst>
              </a:tr>
              <a:tr h="25163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100" u="none" strike="noStrike" dirty="0">
                          <a:effectLst/>
                        </a:rPr>
                        <a:t>PXS64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0.44661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extLst>
                  <a:ext uri="{0D108BD9-81ED-4DB2-BD59-A6C34878D82A}">
                    <a16:rowId xmlns:a16="http://schemas.microsoft.com/office/drawing/2014/main" val="1122567473"/>
                  </a:ext>
                </a:extLst>
              </a:tr>
              <a:tr h="25163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100" u="none" strike="noStrike" dirty="0">
                          <a:effectLst/>
                        </a:rPr>
                        <a:t>PXS64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0.467165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extLst>
                  <a:ext uri="{0D108BD9-81ED-4DB2-BD59-A6C34878D82A}">
                    <a16:rowId xmlns:a16="http://schemas.microsoft.com/office/drawing/2014/main" val="1072419202"/>
                  </a:ext>
                </a:extLst>
              </a:tr>
              <a:tr h="234974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100" u="none" strike="noStrike" dirty="0">
                          <a:effectLst/>
                        </a:rPr>
                        <a:t>PXS64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0.40397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extLst>
                  <a:ext uri="{0D108BD9-81ED-4DB2-BD59-A6C34878D82A}">
                    <a16:rowId xmlns:a16="http://schemas.microsoft.com/office/drawing/2014/main" val="3150960579"/>
                  </a:ext>
                </a:extLst>
              </a:tr>
              <a:tr h="254700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100" u="none" strike="noStrike" dirty="0">
                          <a:effectLst/>
                        </a:rPr>
                        <a:t>PXS64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 dirty="0">
                          <a:effectLst/>
                        </a:rPr>
                        <a:t>0.350653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041" marR="3041" marT="3041" marB="0" anchor="b"/>
                </a:tc>
                <a:extLst>
                  <a:ext uri="{0D108BD9-81ED-4DB2-BD59-A6C34878D82A}">
                    <a16:rowId xmlns:a16="http://schemas.microsoft.com/office/drawing/2014/main" val="1288016834"/>
                  </a:ext>
                </a:extLst>
              </a:tr>
            </a:tbl>
          </a:graphicData>
        </a:graphic>
      </p:graphicFrame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8681485"/>
              </p:ext>
            </p:extLst>
          </p:nvPr>
        </p:nvGraphicFramePr>
        <p:xfrm>
          <a:off x="1648304" y="703460"/>
          <a:ext cx="1249310" cy="445712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07377">
                  <a:extLst>
                    <a:ext uri="{9D8B030D-6E8A-4147-A177-3AD203B41FA5}">
                      <a16:colId xmlns:a16="http://schemas.microsoft.com/office/drawing/2014/main" val="2544684527"/>
                    </a:ext>
                  </a:extLst>
                </a:gridCol>
                <a:gridCol w="441933">
                  <a:extLst>
                    <a:ext uri="{9D8B030D-6E8A-4147-A177-3AD203B41FA5}">
                      <a16:colId xmlns:a16="http://schemas.microsoft.com/office/drawing/2014/main" val="1486770391"/>
                    </a:ext>
                  </a:extLst>
                </a:gridCol>
              </a:tblGrid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1174514069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>
                          <a:effectLst/>
                        </a:rPr>
                        <a:t>Sham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11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497241959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23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2403704051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16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116530187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 dirty="0">
                          <a:effectLst/>
                        </a:rPr>
                        <a:t>0.174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3694907449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3954343592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1182498912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72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64840898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.60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2962552874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5.42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2500705601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.56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1938160622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5.29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2954346570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2.77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3731020462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8.51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684582299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8.67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118647334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.166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2988777017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Telmisartan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92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3381132614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Telmisartan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846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21803482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Telmisartan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.37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3199439996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Telmisartan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.88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613558628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Telmisartan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8.38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3463745012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Telmisartan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.60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328010119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Telmisartan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8.3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222825634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Telmisartan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8.3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3658040289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186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3982295126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.6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2263073941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.166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961645703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.50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4066789816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50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3798888398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27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2774840751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32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3886322977"/>
                  </a:ext>
                </a:extLst>
              </a:tr>
              <a:tr h="135979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 dirty="0">
                          <a:effectLst/>
                        </a:rPr>
                        <a:t>1.457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2125" marR="2125" marT="2125" marB="0" anchor="b"/>
                </a:tc>
                <a:extLst>
                  <a:ext uri="{0D108BD9-81ED-4DB2-BD59-A6C34878D82A}">
                    <a16:rowId xmlns:a16="http://schemas.microsoft.com/office/drawing/2014/main" val="2201882353"/>
                  </a:ext>
                </a:extLst>
              </a:tr>
            </a:tbl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01551611"/>
              </p:ext>
            </p:extLst>
          </p:nvPr>
        </p:nvGraphicFramePr>
        <p:xfrm>
          <a:off x="1397850" y="5123444"/>
          <a:ext cx="1755569" cy="16414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2" name="Prism 8" r:id="rId7" imgW="3442532" imgH="3219181" progId="Prism8.Document">
                  <p:embed/>
                </p:oleObj>
              </mc:Choice>
              <mc:Fallback>
                <p:oleObj name="Prism 8" r:id="rId7" imgW="3442532" imgH="321918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397850" y="5123444"/>
                        <a:ext cx="1755569" cy="16414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1735087"/>
              </p:ext>
            </p:extLst>
          </p:nvPr>
        </p:nvGraphicFramePr>
        <p:xfrm>
          <a:off x="3728692" y="5205163"/>
          <a:ext cx="1653127" cy="15442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3" name="Prism 8" r:id="rId9" imgW="3445772" imgH="3219181" progId="Prism8.Document">
                  <p:embed/>
                </p:oleObj>
              </mc:Choice>
              <mc:Fallback>
                <p:oleObj name="Prism 8" r:id="rId9" imgW="3445772" imgH="321918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728692" y="5205163"/>
                        <a:ext cx="1653127" cy="15442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3495333"/>
              </p:ext>
            </p:extLst>
          </p:nvPr>
        </p:nvGraphicFramePr>
        <p:xfrm>
          <a:off x="3784141" y="689787"/>
          <a:ext cx="1350089" cy="447225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01615">
                  <a:extLst>
                    <a:ext uri="{9D8B030D-6E8A-4147-A177-3AD203B41FA5}">
                      <a16:colId xmlns:a16="http://schemas.microsoft.com/office/drawing/2014/main" val="3142242401"/>
                    </a:ext>
                  </a:extLst>
                </a:gridCol>
                <a:gridCol w="548474">
                  <a:extLst>
                    <a:ext uri="{9D8B030D-6E8A-4147-A177-3AD203B41FA5}">
                      <a16:colId xmlns:a16="http://schemas.microsoft.com/office/drawing/2014/main" val="3832858184"/>
                    </a:ext>
                  </a:extLst>
                </a:gridCol>
              </a:tblGrid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2124278595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75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91758473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74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983759047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82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3510743570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1831460619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3648578714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.02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343317642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.07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774114982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9.31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4179372682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8.35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1432492328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.28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3953246080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7.6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3636820516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8.51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389425120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.85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1394896362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.39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1199773035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3.31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4077831382"/>
                  </a:ext>
                </a:extLst>
              </a:tr>
              <a:tr h="141906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Telmisartan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3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634064257"/>
                  </a:ext>
                </a:extLst>
              </a:tr>
              <a:tr h="141906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Telmisartan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08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1646765230"/>
                  </a:ext>
                </a:extLst>
              </a:tr>
              <a:tr h="141906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Telmisartan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.47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2061716686"/>
                  </a:ext>
                </a:extLst>
              </a:tr>
              <a:tr h="141906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Telmisartan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39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2835490059"/>
                  </a:ext>
                </a:extLst>
              </a:tr>
              <a:tr h="141906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Telmisartan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63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1554516163"/>
                  </a:ext>
                </a:extLst>
              </a:tr>
              <a:tr h="141906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Telmisartan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5.02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4268572582"/>
                  </a:ext>
                </a:extLst>
              </a:tr>
              <a:tr h="141906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Telmisartan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37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2385150252"/>
                  </a:ext>
                </a:extLst>
              </a:tr>
              <a:tr h="141906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Telmisartan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.536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2693791676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.06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3183447232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03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1642176761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.10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2221564166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.16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4264559117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10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952767646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.16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3214885455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.5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1334090364"/>
                  </a:ext>
                </a:extLst>
              </a:tr>
              <a:tr h="134003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 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 dirty="0">
                          <a:effectLst/>
                        </a:rPr>
                        <a:t>1.135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337875899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693347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/>
          <p:cNvSpPr txBox="1"/>
          <p:nvPr/>
        </p:nvSpPr>
        <p:spPr>
          <a:xfrm>
            <a:off x="354091" y="76783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Fig 5E</a:t>
            </a:r>
            <a:endParaRPr lang="en-AU" b="1" dirty="0">
              <a:solidFill>
                <a:srgbClr val="FF0000"/>
              </a:solidFill>
            </a:endParaRPr>
          </a:p>
        </p:txBody>
      </p:sp>
      <p:graphicFrame>
        <p:nvGraphicFramePr>
          <p:cNvPr id="25" name="Object 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04067792"/>
              </p:ext>
            </p:extLst>
          </p:nvPr>
        </p:nvGraphicFramePr>
        <p:xfrm>
          <a:off x="9833907" y="1635031"/>
          <a:ext cx="2589463" cy="20376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4" name="Prism 8" r:id="rId3" imgW="3707841" imgH="2501247" progId="Prism8.Document">
                  <p:embed/>
                </p:oleObj>
              </mc:Choice>
              <mc:Fallback>
                <p:oleObj name="Prism 8" r:id="rId3" imgW="3707841" imgH="2501247" progId="Prism8.Document">
                  <p:embed/>
                  <p:pic>
                    <p:nvPicPr>
                      <p:cNvPr id="25" name="Object 2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833907" y="1635031"/>
                        <a:ext cx="2589463" cy="20376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8185415"/>
              </p:ext>
            </p:extLst>
          </p:nvPr>
        </p:nvGraphicFramePr>
        <p:xfrm>
          <a:off x="135062" y="651326"/>
          <a:ext cx="2077020" cy="4267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92340">
                  <a:extLst>
                    <a:ext uri="{9D8B030D-6E8A-4147-A177-3AD203B41FA5}">
                      <a16:colId xmlns:a16="http://schemas.microsoft.com/office/drawing/2014/main" val="2495527060"/>
                    </a:ext>
                  </a:extLst>
                </a:gridCol>
                <a:gridCol w="692340">
                  <a:extLst>
                    <a:ext uri="{9D8B030D-6E8A-4147-A177-3AD203B41FA5}">
                      <a16:colId xmlns:a16="http://schemas.microsoft.com/office/drawing/2014/main" val="1787702132"/>
                    </a:ext>
                  </a:extLst>
                </a:gridCol>
                <a:gridCol w="692340">
                  <a:extLst>
                    <a:ext uri="{9D8B030D-6E8A-4147-A177-3AD203B41FA5}">
                      <a16:colId xmlns:a16="http://schemas.microsoft.com/office/drawing/2014/main" val="1185670307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Average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87637122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Sham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067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35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98338046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069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53672865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205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78757369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1.139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68620497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27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78470256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Sham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1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436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74324792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005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20378797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1.097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25683031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69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54262353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289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2640972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Sham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071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255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48842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27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40164308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766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428204199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117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95647958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049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67201821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Sham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78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475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42531870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19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9800227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499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12302380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65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7423461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247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059254328"/>
                  </a:ext>
                </a:extLst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49846286"/>
              </p:ext>
            </p:extLst>
          </p:nvPr>
        </p:nvGraphicFramePr>
        <p:xfrm>
          <a:off x="2653767" y="651325"/>
          <a:ext cx="2098923" cy="435185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99641">
                  <a:extLst>
                    <a:ext uri="{9D8B030D-6E8A-4147-A177-3AD203B41FA5}">
                      <a16:colId xmlns:a16="http://schemas.microsoft.com/office/drawing/2014/main" val="1955099135"/>
                    </a:ext>
                  </a:extLst>
                </a:gridCol>
                <a:gridCol w="699641">
                  <a:extLst>
                    <a:ext uri="{9D8B030D-6E8A-4147-A177-3AD203B41FA5}">
                      <a16:colId xmlns:a16="http://schemas.microsoft.com/office/drawing/2014/main" val="472751018"/>
                    </a:ext>
                  </a:extLst>
                </a:gridCol>
                <a:gridCol w="699641">
                  <a:extLst>
                    <a:ext uri="{9D8B030D-6E8A-4147-A177-3AD203B41FA5}">
                      <a16:colId xmlns:a16="http://schemas.microsoft.com/office/drawing/2014/main" val="862013685"/>
                    </a:ext>
                  </a:extLst>
                </a:gridCol>
              </a:tblGrid>
              <a:tr h="207231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Average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994732104"/>
                  </a:ext>
                </a:extLst>
              </a:tr>
              <a:tr h="207231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UUO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4.29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4.817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9783341"/>
                  </a:ext>
                </a:extLst>
              </a:tr>
              <a:tr h="207231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5.91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537902439"/>
                  </a:ext>
                </a:extLst>
              </a:tr>
              <a:tr h="207231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3.48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020151747"/>
                  </a:ext>
                </a:extLst>
              </a:tr>
              <a:tr h="207231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5.305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643951630"/>
                  </a:ext>
                </a:extLst>
              </a:tr>
              <a:tr h="207231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5.09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355079334"/>
                  </a:ext>
                </a:extLst>
              </a:tr>
              <a:tr h="207231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 dirty="0">
                          <a:effectLst/>
                        </a:rPr>
                        <a:t>UUO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6.26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6.57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453369382"/>
                  </a:ext>
                </a:extLst>
              </a:tr>
              <a:tr h="207231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6.7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803276662"/>
                  </a:ext>
                </a:extLst>
              </a:tr>
              <a:tr h="207231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6.21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069532935"/>
                  </a:ext>
                </a:extLst>
              </a:tr>
              <a:tr h="207231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6.24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865213908"/>
                  </a:ext>
                </a:extLst>
              </a:tr>
              <a:tr h="207231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7.427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184808224"/>
                  </a:ext>
                </a:extLst>
              </a:tr>
              <a:tr h="207231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UUO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4.09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5.255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4040899051"/>
                  </a:ext>
                </a:extLst>
              </a:tr>
              <a:tr h="207231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2.51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252262404"/>
                  </a:ext>
                </a:extLst>
              </a:tr>
              <a:tr h="207231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6.28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513788404"/>
                  </a:ext>
                </a:extLst>
              </a:tr>
              <a:tr h="207231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6.969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768322143"/>
                  </a:ext>
                </a:extLst>
              </a:tr>
              <a:tr h="207231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6.41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368826645"/>
                  </a:ext>
                </a:extLst>
              </a:tr>
              <a:tr h="207231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UUO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4.78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5.883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4021553886"/>
                  </a:ext>
                </a:extLst>
              </a:tr>
              <a:tr h="207231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3.49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947562676"/>
                  </a:ext>
                </a:extLst>
              </a:tr>
              <a:tr h="207231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7.499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409968869"/>
                  </a:ext>
                </a:extLst>
              </a:tr>
              <a:tr h="207231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8.69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34846015"/>
                  </a:ext>
                </a:extLst>
              </a:tr>
              <a:tr h="207231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4.947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600494825"/>
                  </a:ext>
                </a:extLst>
              </a:tr>
            </a:tbl>
          </a:graphicData>
        </a:graphic>
      </p:graphicFrame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9208728"/>
              </p:ext>
            </p:extLst>
          </p:nvPr>
        </p:nvGraphicFramePr>
        <p:xfrm>
          <a:off x="4961401" y="651326"/>
          <a:ext cx="2323416" cy="435185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18659">
                  <a:extLst>
                    <a:ext uri="{9D8B030D-6E8A-4147-A177-3AD203B41FA5}">
                      <a16:colId xmlns:a16="http://schemas.microsoft.com/office/drawing/2014/main" val="2934737422"/>
                    </a:ext>
                  </a:extLst>
                </a:gridCol>
                <a:gridCol w="627243">
                  <a:extLst>
                    <a:ext uri="{9D8B030D-6E8A-4147-A177-3AD203B41FA5}">
                      <a16:colId xmlns:a16="http://schemas.microsoft.com/office/drawing/2014/main" val="2467938806"/>
                    </a:ext>
                  </a:extLst>
                </a:gridCol>
                <a:gridCol w="777514">
                  <a:extLst>
                    <a:ext uri="{9D8B030D-6E8A-4147-A177-3AD203B41FA5}">
                      <a16:colId xmlns:a16="http://schemas.microsoft.com/office/drawing/2014/main" val="4113637194"/>
                    </a:ext>
                  </a:extLst>
                </a:gridCol>
              </a:tblGrid>
              <a:tr h="180064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 dirty="0">
                          <a:effectLst/>
                        </a:rPr>
                        <a:t> 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 dirty="0">
                          <a:effectLst/>
                        </a:rPr>
                        <a:t> 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200" u="none" strike="noStrike">
                          <a:effectLst/>
                        </a:rPr>
                        <a:t>Average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extLst>
                  <a:ext uri="{0D108BD9-81ED-4DB2-BD59-A6C34878D82A}">
                    <a16:rowId xmlns:a16="http://schemas.microsoft.com/office/drawing/2014/main" val="2248069214"/>
                  </a:ext>
                </a:extLst>
              </a:tr>
              <a:tr h="279744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200" u="none" strike="noStrike">
                          <a:effectLst/>
                        </a:rPr>
                        <a:t> Telmisartan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>
                          <a:effectLst/>
                        </a:rPr>
                        <a:t>1.571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 dirty="0">
                          <a:effectLst/>
                        </a:rPr>
                        <a:t>0.7792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extLst>
                  <a:ext uri="{0D108BD9-81ED-4DB2-BD59-A6C34878D82A}">
                    <a16:rowId xmlns:a16="http://schemas.microsoft.com/office/drawing/2014/main" val="2124545746"/>
                  </a:ext>
                </a:extLst>
              </a:tr>
              <a:tr h="180064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 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>
                          <a:effectLst/>
                        </a:rPr>
                        <a:t>0.69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 dirty="0">
                          <a:effectLst/>
                        </a:rPr>
                        <a:t> 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extLst>
                  <a:ext uri="{0D108BD9-81ED-4DB2-BD59-A6C34878D82A}">
                    <a16:rowId xmlns:a16="http://schemas.microsoft.com/office/drawing/2014/main" val="1279259125"/>
                  </a:ext>
                </a:extLst>
              </a:tr>
              <a:tr h="180064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 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>
                          <a:effectLst/>
                        </a:rPr>
                        <a:t>1.39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 dirty="0">
                          <a:effectLst/>
                        </a:rPr>
                        <a:t> 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extLst>
                  <a:ext uri="{0D108BD9-81ED-4DB2-BD59-A6C34878D82A}">
                    <a16:rowId xmlns:a16="http://schemas.microsoft.com/office/drawing/2014/main" val="363493935"/>
                  </a:ext>
                </a:extLst>
              </a:tr>
              <a:tr h="180064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 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>
                          <a:effectLst/>
                        </a:rPr>
                        <a:t>0.17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 dirty="0">
                          <a:effectLst/>
                        </a:rPr>
                        <a:t> 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extLst>
                  <a:ext uri="{0D108BD9-81ED-4DB2-BD59-A6C34878D82A}">
                    <a16:rowId xmlns:a16="http://schemas.microsoft.com/office/drawing/2014/main" val="1833040260"/>
                  </a:ext>
                </a:extLst>
              </a:tr>
              <a:tr h="180064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 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>
                          <a:effectLst/>
                        </a:rPr>
                        <a:t>0.069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 dirty="0">
                          <a:effectLst/>
                        </a:rPr>
                        <a:t> 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extLst>
                  <a:ext uri="{0D108BD9-81ED-4DB2-BD59-A6C34878D82A}">
                    <a16:rowId xmlns:a16="http://schemas.microsoft.com/office/drawing/2014/main" val="591357548"/>
                  </a:ext>
                </a:extLst>
              </a:tr>
              <a:tr h="279744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200" u="none" strike="noStrike">
                          <a:effectLst/>
                        </a:rPr>
                        <a:t> Telmisartan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 dirty="0">
                          <a:effectLst/>
                        </a:rPr>
                        <a:t>0.323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 dirty="0">
                          <a:effectLst/>
                        </a:rPr>
                        <a:t>0.689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extLst>
                  <a:ext uri="{0D108BD9-81ED-4DB2-BD59-A6C34878D82A}">
                    <a16:rowId xmlns:a16="http://schemas.microsoft.com/office/drawing/2014/main" val="697880228"/>
                  </a:ext>
                </a:extLst>
              </a:tr>
              <a:tr h="180064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 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>
                          <a:effectLst/>
                        </a:rPr>
                        <a:t>1.149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 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extLst>
                  <a:ext uri="{0D108BD9-81ED-4DB2-BD59-A6C34878D82A}">
                    <a16:rowId xmlns:a16="http://schemas.microsoft.com/office/drawing/2014/main" val="2249235587"/>
                  </a:ext>
                </a:extLst>
              </a:tr>
              <a:tr h="180064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 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>
                          <a:effectLst/>
                        </a:rPr>
                        <a:t>0.301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 dirty="0">
                          <a:effectLst/>
                        </a:rPr>
                        <a:t> 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extLst>
                  <a:ext uri="{0D108BD9-81ED-4DB2-BD59-A6C34878D82A}">
                    <a16:rowId xmlns:a16="http://schemas.microsoft.com/office/drawing/2014/main" val="4024082796"/>
                  </a:ext>
                </a:extLst>
              </a:tr>
              <a:tr h="180064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 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>
                          <a:effectLst/>
                        </a:rPr>
                        <a:t>0.671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 dirty="0">
                          <a:effectLst/>
                        </a:rPr>
                        <a:t> 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extLst>
                  <a:ext uri="{0D108BD9-81ED-4DB2-BD59-A6C34878D82A}">
                    <a16:rowId xmlns:a16="http://schemas.microsoft.com/office/drawing/2014/main" val="1429088183"/>
                  </a:ext>
                </a:extLst>
              </a:tr>
              <a:tr h="180064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 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>
                          <a:effectLst/>
                        </a:rPr>
                        <a:t>0.41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 dirty="0">
                          <a:effectLst/>
                        </a:rPr>
                        <a:t> 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extLst>
                  <a:ext uri="{0D108BD9-81ED-4DB2-BD59-A6C34878D82A}">
                    <a16:rowId xmlns:a16="http://schemas.microsoft.com/office/drawing/2014/main" val="402699309"/>
                  </a:ext>
                </a:extLst>
              </a:tr>
              <a:tr h="180064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 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>
                          <a:effectLst/>
                        </a:rPr>
                        <a:t>1.28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 dirty="0">
                          <a:effectLst/>
                        </a:rPr>
                        <a:t> 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extLst>
                  <a:ext uri="{0D108BD9-81ED-4DB2-BD59-A6C34878D82A}">
                    <a16:rowId xmlns:a16="http://schemas.microsoft.com/office/drawing/2014/main" val="954760136"/>
                  </a:ext>
                </a:extLst>
              </a:tr>
              <a:tr h="186816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200" u="none" strike="noStrike">
                          <a:effectLst/>
                        </a:rPr>
                        <a:t>Telmisartan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>
                          <a:effectLst/>
                        </a:rPr>
                        <a:t>0.14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 dirty="0">
                          <a:effectLst/>
                        </a:rPr>
                        <a:t>0.3116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extLst>
                  <a:ext uri="{0D108BD9-81ED-4DB2-BD59-A6C34878D82A}">
                    <a16:rowId xmlns:a16="http://schemas.microsoft.com/office/drawing/2014/main" val="872021383"/>
                  </a:ext>
                </a:extLst>
              </a:tr>
              <a:tr h="180064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 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>
                          <a:effectLst/>
                        </a:rPr>
                        <a:t>0.107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 dirty="0">
                          <a:effectLst/>
                        </a:rPr>
                        <a:t> 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extLst>
                  <a:ext uri="{0D108BD9-81ED-4DB2-BD59-A6C34878D82A}">
                    <a16:rowId xmlns:a16="http://schemas.microsoft.com/office/drawing/2014/main" val="959786327"/>
                  </a:ext>
                </a:extLst>
              </a:tr>
              <a:tr h="180064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 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>
                          <a:effectLst/>
                        </a:rPr>
                        <a:t>1.041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 dirty="0">
                          <a:effectLst/>
                        </a:rPr>
                        <a:t> 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extLst>
                  <a:ext uri="{0D108BD9-81ED-4DB2-BD59-A6C34878D82A}">
                    <a16:rowId xmlns:a16="http://schemas.microsoft.com/office/drawing/2014/main" val="2363138257"/>
                  </a:ext>
                </a:extLst>
              </a:tr>
              <a:tr h="180064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 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>
                          <a:effectLst/>
                        </a:rPr>
                        <a:t>0.109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 dirty="0">
                          <a:effectLst/>
                        </a:rPr>
                        <a:t> 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extLst>
                  <a:ext uri="{0D108BD9-81ED-4DB2-BD59-A6C34878D82A}">
                    <a16:rowId xmlns:a16="http://schemas.microsoft.com/office/drawing/2014/main" val="4031791504"/>
                  </a:ext>
                </a:extLst>
              </a:tr>
              <a:tr h="180064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 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>
                          <a:effectLst/>
                        </a:rPr>
                        <a:t>0.15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 dirty="0">
                          <a:effectLst/>
                        </a:rPr>
                        <a:t> 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extLst>
                  <a:ext uri="{0D108BD9-81ED-4DB2-BD59-A6C34878D82A}">
                    <a16:rowId xmlns:a16="http://schemas.microsoft.com/office/drawing/2014/main" val="2452229369"/>
                  </a:ext>
                </a:extLst>
              </a:tr>
              <a:tr h="279744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200" u="none" strike="noStrike">
                          <a:effectLst/>
                        </a:rPr>
                        <a:t> Telmisartan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>
                          <a:effectLst/>
                        </a:rPr>
                        <a:t>1.3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 dirty="0">
                          <a:effectLst/>
                        </a:rPr>
                        <a:t>0.3862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extLst>
                  <a:ext uri="{0D108BD9-81ED-4DB2-BD59-A6C34878D82A}">
                    <a16:rowId xmlns:a16="http://schemas.microsoft.com/office/drawing/2014/main" val="953643089"/>
                  </a:ext>
                </a:extLst>
              </a:tr>
              <a:tr h="180064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 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>
                          <a:effectLst/>
                        </a:rPr>
                        <a:t>0.22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 dirty="0">
                          <a:effectLst/>
                        </a:rPr>
                        <a:t> 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extLst>
                  <a:ext uri="{0D108BD9-81ED-4DB2-BD59-A6C34878D82A}">
                    <a16:rowId xmlns:a16="http://schemas.microsoft.com/office/drawing/2014/main" val="2446617276"/>
                  </a:ext>
                </a:extLst>
              </a:tr>
              <a:tr h="180064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 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>
                          <a:effectLst/>
                        </a:rPr>
                        <a:t>0.1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 dirty="0">
                          <a:effectLst/>
                        </a:rPr>
                        <a:t> 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extLst>
                  <a:ext uri="{0D108BD9-81ED-4DB2-BD59-A6C34878D82A}">
                    <a16:rowId xmlns:a16="http://schemas.microsoft.com/office/drawing/2014/main" val="1435664106"/>
                  </a:ext>
                </a:extLst>
              </a:tr>
              <a:tr h="180064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 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>
                          <a:effectLst/>
                        </a:rPr>
                        <a:t>0.041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 dirty="0">
                          <a:effectLst/>
                        </a:rPr>
                        <a:t> 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extLst>
                  <a:ext uri="{0D108BD9-81ED-4DB2-BD59-A6C34878D82A}">
                    <a16:rowId xmlns:a16="http://schemas.microsoft.com/office/drawing/2014/main" val="1486532214"/>
                  </a:ext>
                </a:extLst>
              </a:tr>
              <a:tr h="180064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 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200" u="none" strike="noStrike">
                          <a:effectLst/>
                        </a:rPr>
                        <a:t>0.156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887" marR="1887" marT="188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 dirty="0">
                          <a:effectLst/>
                        </a:rPr>
                        <a:t> 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7" marR="1887" marT="1887" marB="0" anchor="b"/>
                </a:tc>
                <a:extLst>
                  <a:ext uri="{0D108BD9-81ED-4DB2-BD59-A6C34878D82A}">
                    <a16:rowId xmlns:a16="http://schemas.microsoft.com/office/drawing/2014/main" val="3353324363"/>
                  </a:ext>
                </a:extLst>
              </a:tr>
            </a:tbl>
          </a:graphicData>
        </a:graphic>
      </p:graphicFrame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02814386"/>
              </p:ext>
            </p:extLst>
          </p:nvPr>
        </p:nvGraphicFramePr>
        <p:xfrm>
          <a:off x="7395507" y="651326"/>
          <a:ext cx="2438400" cy="441346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12800">
                  <a:extLst>
                    <a:ext uri="{9D8B030D-6E8A-4147-A177-3AD203B41FA5}">
                      <a16:colId xmlns:a16="http://schemas.microsoft.com/office/drawing/2014/main" val="861957685"/>
                    </a:ext>
                  </a:extLst>
                </a:gridCol>
                <a:gridCol w="812800">
                  <a:extLst>
                    <a:ext uri="{9D8B030D-6E8A-4147-A177-3AD203B41FA5}">
                      <a16:colId xmlns:a16="http://schemas.microsoft.com/office/drawing/2014/main" val="2551745801"/>
                    </a:ext>
                  </a:extLst>
                </a:gridCol>
                <a:gridCol w="812800">
                  <a:extLst>
                    <a:ext uri="{9D8B030D-6E8A-4147-A177-3AD203B41FA5}">
                      <a16:colId xmlns:a16="http://schemas.microsoft.com/office/drawing/2014/main" val="653576006"/>
                    </a:ext>
                  </a:extLst>
                </a:gridCol>
              </a:tblGrid>
              <a:tr h="210165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Average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640310559"/>
                  </a:ext>
                </a:extLst>
              </a:tr>
              <a:tr h="210165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PSX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061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213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123813864"/>
                  </a:ext>
                </a:extLst>
              </a:tr>
              <a:tr h="210165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01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114331528"/>
                  </a:ext>
                </a:extLst>
              </a:tr>
              <a:tr h="210165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14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01678913"/>
                  </a:ext>
                </a:extLst>
              </a:tr>
              <a:tr h="210165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381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641159896"/>
                  </a:ext>
                </a:extLst>
              </a:tr>
              <a:tr h="210165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47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156391073"/>
                  </a:ext>
                </a:extLst>
              </a:tr>
              <a:tr h="210165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PSX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189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28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843889553"/>
                  </a:ext>
                </a:extLst>
              </a:tr>
              <a:tr h="210165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40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36632709"/>
                  </a:ext>
                </a:extLst>
              </a:tr>
              <a:tr h="210165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23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543613476"/>
                  </a:ext>
                </a:extLst>
              </a:tr>
              <a:tr h="210165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18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297468174"/>
                  </a:ext>
                </a:extLst>
              </a:tr>
              <a:tr h="210165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401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466631143"/>
                  </a:ext>
                </a:extLst>
              </a:tr>
              <a:tr h="210165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PSX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099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350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008513324"/>
                  </a:ext>
                </a:extLst>
              </a:tr>
              <a:tr h="210165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385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436140988"/>
                  </a:ext>
                </a:extLst>
              </a:tr>
              <a:tr h="210165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477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75821306"/>
                  </a:ext>
                </a:extLst>
              </a:tr>
              <a:tr h="210165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39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83870621"/>
                  </a:ext>
                </a:extLst>
              </a:tr>
              <a:tr h="210165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399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746226244"/>
                  </a:ext>
                </a:extLst>
              </a:tr>
              <a:tr h="210165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PSX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1.585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96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773819583"/>
                  </a:ext>
                </a:extLst>
              </a:tr>
              <a:tr h="210165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035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426192440"/>
                  </a:ext>
                </a:extLst>
              </a:tr>
              <a:tr h="210165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1.21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281127376"/>
                  </a:ext>
                </a:extLst>
              </a:tr>
              <a:tr h="210165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696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140940478"/>
                  </a:ext>
                </a:extLst>
              </a:tr>
              <a:tr h="210165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1.306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97442084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01797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6" name="Object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1668944"/>
              </p:ext>
            </p:extLst>
          </p:nvPr>
        </p:nvGraphicFramePr>
        <p:xfrm>
          <a:off x="9243012" y="1741193"/>
          <a:ext cx="2790910" cy="18068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8" name="Prism 8" r:id="rId3" imgW="3788477" imgH="2501247" progId="Prism8.Document">
                  <p:embed/>
                </p:oleObj>
              </mc:Choice>
              <mc:Fallback>
                <p:oleObj name="Prism 8" r:id="rId3" imgW="3788477" imgH="2501247" progId="Prism8.Document">
                  <p:embed/>
                  <p:pic>
                    <p:nvPicPr>
                      <p:cNvPr id="26" name="Object 25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243012" y="1741193"/>
                        <a:ext cx="2790910" cy="18068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TextBox 27"/>
          <p:cNvSpPr txBox="1"/>
          <p:nvPr/>
        </p:nvSpPr>
        <p:spPr>
          <a:xfrm>
            <a:off x="371724" y="101905"/>
            <a:ext cx="7312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Fig 5F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79096042"/>
              </p:ext>
            </p:extLst>
          </p:nvPr>
        </p:nvGraphicFramePr>
        <p:xfrm>
          <a:off x="523818" y="1059956"/>
          <a:ext cx="1896331" cy="4267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6747">
                  <a:extLst>
                    <a:ext uri="{9D8B030D-6E8A-4147-A177-3AD203B41FA5}">
                      <a16:colId xmlns:a16="http://schemas.microsoft.com/office/drawing/2014/main" val="1289612239"/>
                    </a:ext>
                  </a:extLst>
                </a:gridCol>
                <a:gridCol w="673481">
                  <a:extLst>
                    <a:ext uri="{9D8B030D-6E8A-4147-A177-3AD203B41FA5}">
                      <a16:colId xmlns:a16="http://schemas.microsoft.com/office/drawing/2014/main" val="1427776673"/>
                    </a:ext>
                  </a:extLst>
                </a:gridCol>
                <a:gridCol w="646103">
                  <a:extLst>
                    <a:ext uri="{9D8B030D-6E8A-4147-A177-3AD203B41FA5}">
                      <a16:colId xmlns:a16="http://schemas.microsoft.com/office/drawing/2014/main" val="464298590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Average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66447627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Sham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06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095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8680588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08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17833949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10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62853359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08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415033792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135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98267931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Sham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93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2.290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32348412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1.01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15079256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3.20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53781068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3.06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74735667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3.237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32431834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Sham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1.709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1.897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81806653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1.1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04424546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1.447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79945649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3.00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94029501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2.185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58069395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Sham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421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256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39278114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326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77070267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12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95929818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97002334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21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312749591"/>
                  </a:ext>
                </a:extLst>
              </a:tr>
            </a:tbl>
          </a:graphicData>
        </a:graphic>
      </p:graphicFrame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70080673"/>
              </p:ext>
            </p:extLst>
          </p:nvPr>
        </p:nvGraphicFramePr>
        <p:xfrm>
          <a:off x="2622682" y="1059956"/>
          <a:ext cx="1823383" cy="4267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25701">
                  <a:extLst>
                    <a:ext uri="{9D8B030D-6E8A-4147-A177-3AD203B41FA5}">
                      <a16:colId xmlns:a16="http://schemas.microsoft.com/office/drawing/2014/main" val="774703561"/>
                    </a:ext>
                  </a:extLst>
                </a:gridCol>
                <a:gridCol w="602300">
                  <a:extLst>
                    <a:ext uri="{9D8B030D-6E8A-4147-A177-3AD203B41FA5}">
                      <a16:colId xmlns:a16="http://schemas.microsoft.com/office/drawing/2014/main" val="2424371955"/>
                    </a:ext>
                  </a:extLst>
                </a:gridCol>
                <a:gridCol w="695382">
                  <a:extLst>
                    <a:ext uri="{9D8B030D-6E8A-4147-A177-3AD203B41FA5}">
                      <a16:colId xmlns:a16="http://schemas.microsoft.com/office/drawing/2014/main" val="2335246084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Average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65854717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UUO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8.667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8.350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4505792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12.80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97676738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6.197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416592641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7.04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6623539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7.04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62490744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UUO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16.601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9.830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5728648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13.485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55276731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5.09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29540358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4.92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34244275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9.046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90956905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UUO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10.06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9.359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82002151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10.93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32101240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8.28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1610555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7.48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421352873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10.02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58570438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UUO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8.667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8.9166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405748482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11.27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25709309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7.997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25741650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8.02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40415852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8.62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726309473"/>
                  </a:ext>
                </a:extLst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07357457"/>
              </p:ext>
            </p:extLst>
          </p:nvPr>
        </p:nvGraphicFramePr>
        <p:xfrm>
          <a:off x="4701585" y="1059956"/>
          <a:ext cx="2066070" cy="4267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12800">
                  <a:extLst>
                    <a:ext uri="{9D8B030D-6E8A-4147-A177-3AD203B41FA5}">
                      <a16:colId xmlns:a16="http://schemas.microsoft.com/office/drawing/2014/main" val="3196817012"/>
                    </a:ext>
                  </a:extLst>
                </a:gridCol>
                <a:gridCol w="634544">
                  <a:extLst>
                    <a:ext uri="{9D8B030D-6E8A-4147-A177-3AD203B41FA5}">
                      <a16:colId xmlns:a16="http://schemas.microsoft.com/office/drawing/2014/main" val="3603314835"/>
                    </a:ext>
                  </a:extLst>
                </a:gridCol>
                <a:gridCol w="618726">
                  <a:extLst>
                    <a:ext uri="{9D8B030D-6E8A-4147-A177-3AD203B41FA5}">
                      <a16:colId xmlns:a16="http://schemas.microsoft.com/office/drawing/2014/main" val="1945103057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Average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29594112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Telmisartan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7.407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5.425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28162541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6.19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86963529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4.62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80452335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5.291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01486455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3.61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4310247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Telmisartan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6.741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4.9586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52104241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4.537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53690031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4.31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63456087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4.71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62327478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4.49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25925822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Telmisartan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5.98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 dirty="0">
                          <a:effectLst/>
                        </a:rPr>
                        <a:t>4.370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73804286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4.47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982271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5.161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16132210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1.82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17304229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4.40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91250684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Telmisartan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5.09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5.039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45279708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6.405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66667591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5.4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427884484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4.656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47891847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3.61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4196372851"/>
                  </a:ext>
                </a:extLst>
              </a:tr>
            </a:tbl>
          </a:graphicData>
        </a:graphic>
      </p:graphicFrame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9082249"/>
              </p:ext>
            </p:extLst>
          </p:nvPr>
        </p:nvGraphicFramePr>
        <p:xfrm>
          <a:off x="7094355" y="1059956"/>
          <a:ext cx="1874431" cy="4267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26028">
                  <a:extLst>
                    <a:ext uri="{9D8B030D-6E8A-4147-A177-3AD203B41FA5}">
                      <a16:colId xmlns:a16="http://schemas.microsoft.com/office/drawing/2014/main" val="2756806783"/>
                    </a:ext>
                  </a:extLst>
                </a:gridCol>
                <a:gridCol w="651579">
                  <a:extLst>
                    <a:ext uri="{9D8B030D-6E8A-4147-A177-3AD203B41FA5}">
                      <a16:colId xmlns:a16="http://schemas.microsoft.com/office/drawing/2014/main" val="940028821"/>
                    </a:ext>
                  </a:extLst>
                </a:gridCol>
                <a:gridCol w="596824">
                  <a:extLst>
                    <a:ext uri="{9D8B030D-6E8A-4147-A177-3AD203B41FA5}">
                      <a16:colId xmlns:a16="http://schemas.microsoft.com/office/drawing/2014/main" val="1979493533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Average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411007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PSX6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7.585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 dirty="0">
                          <a:effectLst/>
                        </a:rPr>
                        <a:t>6.815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40123136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7.665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64696191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9.045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11542868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2.252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94565207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7.52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25722587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PSX6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3.1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4.0136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38722514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3.941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9056860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5.035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56498915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3.77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85779474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4.17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60801009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PSX6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445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3.2926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78750764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2.477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14824557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5.131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55728235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8.00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80245022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0.406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61306826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PSX6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3.04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4.030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43363880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3.96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50306179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5.06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55821677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3.766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95831112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200" u="none" strike="noStrike">
                          <a:effectLst/>
                        </a:rPr>
                        <a:t>4.315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53569111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058036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757163" y="153340"/>
            <a:ext cx="1060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Figure 6C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99810" y="130564"/>
            <a:ext cx="12272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Figures 6 A</a:t>
            </a:r>
          </a:p>
        </p:txBody>
      </p:sp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02669947"/>
              </p:ext>
            </p:extLst>
          </p:nvPr>
        </p:nvGraphicFramePr>
        <p:xfrm>
          <a:off x="5509666" y="5421504"/>
          <a:ext cx="1840967" cy="156170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2" name="Prism 8" r:id="rId3" imgW="3515609" imgH="2982991" progId="Prism8.Document">
                  <p:embed/>
                </p:oleObj>
              </mc:Choice>
              <mc:Fallback>
                <p:oleObj name="Prism 8" r:id="rId3" imgW="3515609" imgH="2982991" progId="Prism8.Document">
                  <p:embed/>
                  <p:pic>
                    <p:nvPicPr>
                      <p:cNvPr id="17" name="Object 16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509666" y="5421504"/>
                        <a:ext cx="1840967" cy="156170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Table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54314796"/>
              </p:ext>
            </p:extLst>
          </p:nvPr>
        </p:nvGraphicFramePr>
        <p:xfrm>
          <a:off x="5757163" y="570582"/>
          <a:ext cx="1147090" cy="485092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73545">
                  <a:extLst>
                    <a:ext uri="{9D8B030D-6E8A-4147-A177-3AD203B41FA5}">
                      <a16:colId xmlns:a16="http://schemas.microsoft.com/office/drawing/2014/main" val="1597430183"/>
                    </a:ext>
                  </a:extLst>
                </a:gridCol>
                <a:gridCol w="573545">
                  <a:extLst>
                    <a:ext uri="{9D8B030D-6E8A-4147-A177-3AD203B41FA5}">
                      <a16:colId xmlns:a16="http://schemas.microsoft.com/office/drawing/2014/main" val="517800605"/>
                    </a:ext>
                  </a:extLst>
                </a:gridCol>
              </a:tblGrid>
              <a:tr h="143528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 dirty="0">
                          <a:effectLst/>
                        </a:rPr>
                        <a:t>Sham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900" u="none" strike="noStrike">
                          <a:effectLst/>
                        </a:rPr>
                        <a:t>0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3556166274"/>
                  </a:ext>
                </a:extLst>
              </a:tr>
              <a:tr h="224550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 dirty="0">
                          <a:effectLst/>
                        </a:rPr>
                        <a:t>Sham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900" u="none" strike="noStrike">
                          <a:effectLst/>
                        </a:rPr>
                        <a:t>0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816984041"/>
                  </a:ext>
                </a:extLst>
              </a:tr>
              <a:tr h="224550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 dirty="0">
                          <a:effectLst/>
                        </a:rPr>
                        <a:t>Sham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900" u="none" strike="noStrike">
                          <a:effectLst/>
                        </a:rPr>
                        <a:t>0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1546034210"/>
                  </a:ext>
                </a:extLst>
              </a:tr>
              <a:tr h="224550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 dirty="0">
                          <a:effectLst/>
                        </a:rPr>
                        <a:t>Sham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900" u="none" strike="noStrike" dirty="0">
                          <a:effectLst/>
                        </a:rPr>
                        <a:t>0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831119182"/>
                  </a:ext>
                </a:extLst>
              </a:tr>
              <a:tr h="224550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900" u="none" strike="noStrike" dirty="0">
                          <a:effectLst/>
                        </a:rPr>
                        <a:t>0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1172666852"/>
                  </a:ext>
                </a:extLst>
              </a:tr>
              <a:tr h="224550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900" u="none" strike="noStrike" dirty="0">
                          <a:effectLst/>
                        </a:rPr>
                        <a:t>0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3781116084"/>
                  </a:ext>
                </a:extLst>
              </a:tr>
              <a:tr h="224550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900" u="none" strike="noStrike" dirty="0">
                          <a:effectLst/>
                        </a:rPr>
                        <a:t>16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91293194"/>
                  </a:ext>
                </a:extLst>
              </a:tr>
              <a:tr h="224550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900" u="none" strike="noStrike" dirty="0">
                          <a:effectLst/>
                        </a:rPr>
                        <a:t>776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1351198068"/>
                  </a:ext>
                </a:extLst>
              </a:tr>
              <a:tr h="224550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900" u="none" strike="noStrike" dirty="0">
                          <a:effectLst/>
                        </a:rPr>
                        <a:t>285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671945789"/>
                  </a:ext>
                </a:extLst>
              </a:tr>
              <a:tr h="224550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900" u="none" strike="noStrike" dirty="0">
                          <a:effectLst/>
                        </a:rPr>
                        <a:t>372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3423103105"/>
                  </a:ext>
                </a:extLst>
              </a:tr>
              <a:tr h="224550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900" u="none" strike="noStrike" dirty="0">
                          <a:effectLst/>
                        </a:rPr>
                        <a:t>782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4031285202"/>
                  </a:ext>
                </a:extLst>
              </a:tr>
              <a:tr h="224550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900" u="none" strike="noStrike" dirty="0">
                          <a:effectLst/>
                        </a:rPr>
                        <a:t>782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427408759"/>
                  </a:ext>
                </a:extLst>
              </a:tr>
              <a:tr h="224550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900" u="none" strike="noStrike" dirty="0">
                          <a:effectLst/>
                        </a:rPr>
                        <a:t>69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197640620"/>
                  </a:ext>
                </a:extLst>
              </a:tr>
              <a:tr h="224550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900" u="none" strike="noStrike" dirty="0">
                          <a:effectLst/>
                        </a:rPr>
                        <a:t>79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3329936565"/>
                  </a:ext>
                </a:extLst>
              </a:tr>
              <a:tr h="224550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900" u="none" strike="noStrike" dirty="0">
                          <a:effectLst/>
                        </a:rPr>
                        <a:t>48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1368131942"/>
                  </a:ext>
                </a:extLst>
              </a:tr>
              <a:tr h="217605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900" u="none" strike="noStrike" dirty="0">
                          <a:effectLst/>
                        </a:rPr>
                        <a:t>136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118515836"/>
                  </a:ext>
                </a:extLst>
              </a:tr>
              <a:tr h="217605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 dirty="0">
                          <a:effectLst/>
                        </a:rPr>
                        <a:t>62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3792661154"/>
                  </a:ext>
                </a:extLst>
              </a:tr>
              <a:tr h="217605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PXS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900" u="none" strike="noStrike" dirty="0">
                          <a:effectLst/>
                        </a:rPr>
                        <a:t>0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3298465387"/>
                  </a:ext>
                </a:extLst>
              </a:tr>
              <a:tr h="217605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PXS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900" u="none" strike="noStrike" dirty="0">
                          <a:effectLst/>
                        </a:rPr>
                        <a:t>0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2669875666"/>
                  </a:ext>
                </a:extLst>
              </a:tr>
              <a:tr h="142314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PXS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900" u="none" strike="noStrike" dirty="0">
                          <a:effectLst/>
                        </a:rPr>
                        <a:t>0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1035135056"/>
                  </a:ext>
                </a:extLst>
              </a:tr>
              <a:tr h="189827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PXS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900" u="none" strike="noStrike" dirty="0">
                          <a:effectLst/>
                        </a:rPr>
                        <a:t>0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997792637"/>
                  </a:ext>
                </a:extLst>
              </a:tr>
              <a:tr h="189827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PXS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900" u="none" strike="noStrike" dirty="0">
                          <a:effectLst/>
                        </a:rPr>
                        <a:t>0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1114608266"/>
                  </a:ext>
                </a:extLst>
              </a:tr>
              <a:tr h="171306">
                <a:tc>
                  <a:txBody>
                    <a:bodyPr/>
                    <a:lstStyle/>
                    <a:p>
                      <a:pPr algn="ctr" rtl="0" fontAlgn="b"/>
                      <a:r>
                        <a:rPr lang="en-AU" sz="900" u="none" strike="noStrike">
                          <a:effectLst/>
                        </a:rPr>
                        <a:t>PXS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900" u="none" strike="noStrike" dirty="0">
                          <a:effectLst/>
                        </a:rPr>
                        <a:t>330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079" marR="2079" marT="2079" marB="0" anchor="b"/>
                </a:tc>
                <a:extLst>
                  <a:ext uri="{0D108BD9-81ED-4DB2-BD59-A6C34878D82A}">
                    <a16:rowId xmlns:a16="http://schemas.microsoft.com/office/drawing/2014/main" val="408207009"/>
                  </a:ext>
                </a:extLst>
              </a:tr>
            </a:tbl>
          </a:graphicData>
        </a:graphic>
      </p:graphicFrame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79324607"/>
              </p:ext>
            </p:extLst>
          </p:nvPr>
        </p:nvGraphicFramePr>
        <p:xfrm>
          <a:off x="277331" y="566232"/>
          <a:ext cx="1571534" cy="467414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34538">
                  <a:extLst>
                    <a:ext uri="{9D8B030D-6E8A-4147-A177-3AD203B41FA5}">
                      <a16:colId xmlns:a16="http://schemas.microsoft.com/office/drawing/2014/main" val="181499474"/>
                    </a:ext>
                  </a:extLst>
                </a:gridCol>
                <a:gridCol w="736996">
                  <a:extLst>
                    <a:ext uri="{9D8B030D-6E8A-4147-A177-3AD203B41FA5}">
                      <a16:colId xmlns:a16="http://schemas.microsoft.com/office/drawing/2014/main" val="3913458663"/>
                    </a:ext>
                  </a:extLst>
                </a:gridCol>
              </a:tblGrid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606118141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16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1442369278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3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1977782566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05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877098973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036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1694598414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1722396807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49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835238521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85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1674395612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9.15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465499257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5.68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4090348115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.66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4201384583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8.66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1898737498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8.29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3702548206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5.61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508704059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7.83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1186512252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.71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2524300912"/>
                  </a:ext>
                </a:extLst>
              </a:tr>
              <a:tr h="167142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 err="1">
                          <a:effectLst/>
                        </a:rPr>
                        <a:t>Telmisartan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71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4244593301"/>
                  </a:ext>
                </a:extLst>
              </a:tr>
              <a:tr h="167142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 err="1">
                          <a:effectLst/>
                        </a:rPr>
                        <a:t>Telmisartan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05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1342361749"/>
                  </a:ext>
                </a:extLst>
              </a:tr>
              <a:tr h="167142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>
                          <a:effectLst/>
                        </a:rPr>
                        <a:t> </a:t>
                      </a:r>
                      <a:r>
                        <a:rPr lang="en-AU" sz="900" u="none" strike="noStrike" dirty="0" err="1">
                          <a:effectLst/>
                        </a:rPr>
                        <a:t>Telmisartan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32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1496916241"/>
                  </a:ext>
                </a:extLst>
              </a:tr>
              <a:tr h="167142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>
                          <a:effectLst/>
                        </a:rPr>
                        <a:t> </a:t>
                      </a:r>
                      <a:r>
                        <a:rPr lang="en-AU" sz="900" u="none" strike="noStrike" dirty="0" err="1">
                          <a:effectLst/>
                        </a:rPr>
                        <a:t>Telmisartan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7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1814714553"/>
                  </a:ext>
                </a:extLst>
              </a:tr>
              <a:tr h="167142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>
                          <a:effectLst/>
                        </a:rPr>
                        <a:t> </a:t>
                      </a:r>
                      <a:r>
                        <a:rPr lang="en-AU" sz="900" u="none" strike="noStrike" dirty="0" err="1">
                          <a:effectLst/>
                        </a:rPr>
                        <a:t>Telmisartan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.19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3029788545"/>
                  </a:ext>
                </a:extLst>
              </a:tr>
              <a:tr h="167142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>
                          <a:effectLst/>
                        </a:rPr>
                        <a:t> </a:t>
                      </a:r>
                      <a:r>
                        <a:rPr lang="en-AU" sz="900" u="none" strike="noStrike" dirty="0" err="1">
                          <a:effectLst/>
                        </a:rPr>
                        <a:t>Telmisartan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46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416948138"/>
                  </a:ext>
                </a:extLst>
              </a:tr>
              <a:tr h="167142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 err="1">
                          <a:effectLst/>
                        </a:rPr>
                        <a:t>Telmisartan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.51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953267934"/>
                  </a:ext>
                </a:extLst>
              </a:tr>
              <a:tr h="167142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 err="1">
                          <a:effectLst/>
                        </a:rPr>
                        <a:t>Telmisartan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.97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4172041379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>
                          <a:effectLst/>
                        </a:rPr>
                        <a:t>PSX64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83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3982015213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>
                          <a:effectLst/>
                        </a:rPr>
                        <a:t>PSX64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62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2569928495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>
                          <a:effectLst/>
                        </a:rPr>
                        <a:t>PSX64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.74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2729790422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>
                          <a:effectLst/>
                        </a:rPr>
                        <a:t>PSX64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36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1022180280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>
                          <a:effectLst/>
                        </a:rPr>
                        <a:t>PSX64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19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2671953840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>
                          <a:effectLst/>
                        </a:rPr>
                        <a:t>PSX64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.63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1904668952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>
                          <a:effectLst/>
                        </a:rPr>
                        <a:t>PSX64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12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832282481"/>
                  </a:ext>
                </a:extLst>
              </a:tr>
              <a:tr h="119305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>
                          <a:effectLst/>
                        </a:rPr>
                        <a:t>PSX64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 dirty="0">
                          <a:effectLst/>
                        </a:rPr>
                        <a:t>1.083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882" marR="1882" marT="1882" marB="0" anchor="b"/>
                </a:tc>
                <a:extLst>
                  <a:ext uri="{0D108BD9-81ED-4DB2-BD59-A6C34878D82A}">
                    <a16:rowId xmlns:a16="http://schemas.microsoft.com/office/drawing/2014/main" val="1167364051"/>
                  </a:ext>
                </a:extLst>
              </a:tr>
            </a:tbl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75342155"/>
              </p:ext>
            </p:extLst>
          </p:nvPr>
        </p:nvGraphicFramePr>
        <p:xfrm>
          <a:off x="336128" y="5240376"/>
          <a:ext cx="1962923" cy="18759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3" name="Prism 8" r:id="rId5" imgW="3369455" imgH="3219181" progId="Prism8.Document">
                  <p:embed/>
                </p:oleObj>
              </mc:Choice>
              <mc:Fallback>
                <p:oleObj name="Prism 8" r:id="rId5" imgW="3369455" imgH="321918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36128" y="5240376"/>
                        <a:ext cx="1962923" cy="18759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3218407" y="153340"/>
            <a:ext cx="12272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Figures 6 B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83697437"/>
              </p:ext>
            </p:extLst>
          </p:nvPr>
        </p:nvGraphicFramePr>
        <p:xfrm>
          <a:off x="3048650" y="522672"/>
          <a:ext cx="1764234" cy="483129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90864">
                  <a:extLst>
                    <a:ext uri="{9D8B030D-6E8A-4147-A177-3AD203B41FA5}">
                      <a16:colId xmlns:a16="http://schemas.microsoft.com/office/drawing/2014/main" val="3228941453"/>
                    </a:ext>
                  </a:extLst>
                </a:gridCol>
                <a:gridCol w="973370">
                  <a:extLst>
                    <a:ext uri="{9D8B030D-6E8A-4147-A177-3AD203B41FA5}">
                      <a16:colId xmlns:a16="http://schemas.microsoft.com/office/drawing/2014/main" val="1416145132"/>
                    </a:ext>
                  </a:extLst>
                </a:gridCol>
              </a:tblGrid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50095064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85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2603934640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44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3710271248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4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1485120806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54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2383020005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4188710548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92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24074567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.52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915830105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1.66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3137168946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.24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2808072526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.78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3283326086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6.4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3283675355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8.81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1456922549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.14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3867360217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.92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3474943068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5.74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163285424"/>
                  </a:ext>
                </a:extLst>
              </a:tr>
              <a:tr h="188022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 err="1">
                          <a:effectLst/>
                        </a:rPr>
                        <a:t>Telmisartan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81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2905690442"/>
                  </a:ext>
                </a:extLst>
              </a:tr>
              <a:tr h="188022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 err="1">
                          <a:effectLst/>
                        </a:rPr>
                        <a:t>Telmisartan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82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682744285"/>
                  </a:ext>
                </a:extLst>
              </a:tr>
              <a:tr h="188022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 err="1">
                          <a:effectLst/>
                        </a:rPr>
                        <a:t>Telmisartan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39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2018943463"/>
                  </a:ext>
                </a:extLst>
              </a:tr>
              <a:tr h="188022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 err="1">
                          <a:effectLst/>
                        </a:rPr>
                        <a:t>Telmisartan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63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2669253577"/>
                  </a:ext>
                </a:extLst>
              </a:tr>
              <a:tr h="188022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 err="1">
                          <a:effectLst/>
                        </a:rPr>
                        <a:t>Telmisartan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62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1687825804"/>
                  </a:ext>
                </a:extLst>
              </a:tr>
              <a:tr h="188022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 err="1">
                          <a:effectLst/>
                        </a:rPr>
                        <a:t>Telmisartan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 dirty="0">
                          <a:effectLst/>
                        </a:rPr>
                        <a:t>5.79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1174418523"/>
                  </a:ext>
                </a:extLst>
              </a:tr>
              <a:tr h="188022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 err="1">
                          <a:effectLst/>
                        </a:rPr>
                        <a:t>Telmisartan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34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3783611363"/>
                  </a:ext>
                </a:extLst>
              </a:tr>
              <a:tr h="188022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 err="1">
                          <a:effectLst/>
                        </a:rPr>
                        <a:t>Telmisartan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.916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2003781131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>
                          <a:effectLst/>
                        </a:rPr>
                        <a:t>PSX64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.2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2942940011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>
                          <a:effectLst/>
                        </a:rPr>
                        <a:t>PSX64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.34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2886570328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>
                          <a:effectLst/>
                        </a:rPr>
                        <a:t>PSX64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406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1985287527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>
                          <a:effectLst/>
                        </a:rPr>
                        <a:t>PSX64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62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4075480093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>
                          <a:effectLst/>
                        </a:rPr>
                        <a:t>PSX64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79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577986689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>
                          <a:effectLst/>
                        </a:rPr>
                        <a:t>PSX64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14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1131588564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>
                          <a:effectLst/>
                        </a:rPr>
                        <a:t>PSX64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506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2630396822"/>
                  </a:ext>
                </a:extLst>
              </a:tr>
              <a:tr h="133897">
                <a:tc>
                  <a:txBody>
                    <a:bodyPr/>
                    <a:lstStyle/>
                    <a:p>
                      <a:pPr algn="ctr" fontAlgn="b"/>
                      <a:r>
                        <a:rPr lang="en-AU" sz="900" u="none" strike="noStrike" dirty="0">
                          <a:effectLst/>
                        </a:rPr>
                        <a:t>PSX64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 dirty="0">
                          <a:effectLst/>
                        </a:rPr>
                        <a:t>2.257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1470" marR="1470" marT="1470" marB="0" anchor="b"/>
                </a:tc>
                <a:extLst>
                  <a:ext uri="{0D108BD9-81ED-4DB2-BD59-A6C34878D82A}">
                    <a16:rowId xmlns:a16="http://schemas.microsoft.com/office/drawing/2014/main" val="2539396591"/>
                  </a:ext>
                </a:extLst>
              </a:tr>
            </a:tbl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8269587"/>
              </p:ext>
            </p:extLst>
          </p:nvPr>
        </p:nvGraphicFramePr>
        <p:xfrm>
          <a:off x="3156154" y="5342473"/>
          <a:ext cx="1789655" cy="16717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4" name="Prism 8" r:id="rId7" imgW="3447212" imgH="3219181" progId="Prism8.Document">
                  <p:embed/>
                </p:oleObj>
              </mc:Choice>
              <mc:Fallback>
                <p:oleObj name="Prism 8" r:id="rId7" imgW="3447212" imgH="321918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156154" y="5342473"/>
                        <a:ext cx="1789655" cy="16717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TextBox 6"/>
          <p:cNvSpPr txBox="1">
            <a:spLocks noChangeArrowheads="1"/>
          </p:cNvSpPr>
          <p:nvPr/>
        </p:nvSpPr>
        <p:spPr bwMode="auto">
          <a:xfrm>
            <a:off x="7887610" y="162637"/>
            <a:ext cx="862737" cy="369332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AU" altLang="en-US" b="1" dirty="0"/>
              <a:t>Figs 6D</a:t>
            </a:r>
          </a:p>
        </p:txBody>
      </p:sp>
      <p:graphicFrame>
        <p:nvGraphicFramePr>
          <p:cNvPr id="22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71437548"/>
              </p:ext>
            </p:extLst>
          </p:nvPr>
        </p:nvGraphicFramePr>
        <p:xfrm>
          <a:off x="7801146" y="531969"/>
          <a:ext cx="1625600" cy="493083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16000">
                  <a:extLst>
                    <a:ext uri="{9D8B030D-6E8A-4147-A177-3AD203B41FA5}">
                      <a16:colId xmlns:a16="http://schemas.microsoft.com/office/drawing/2014/main" val="151362534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934760589"/>
                    </a:ext>
                  </a:extLst>
                </a:gridCol>
              </a:tblGrid>
              <a:tr h="379295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 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b="1" u="none" strike="noStrike" dirty="0">
                          <a:effectLst/>
                        </a:rPr>
                        <a:t>F4/80</a:t>
                      </a:r>
                      <a:endParaRPr lang="en-AU" sz="12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965577463"/>
                  </a:ext>
                </a:extLst>
              </a:tr>
              <a:tr h="37929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200" u="none" strike="noStrike" dirty="0">
                          <a:effectLst/>
                        </a:rPr>
                        <a:t>a-Sham     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200" u="none" strike="noStrike">
                          <a:effectLst/>
                        </a:rPr>
                        <a:t>0.49788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4120684650"/>
                  </a:ext>
                </a:extLst>
              </a:tr>
              <a:tr h="37929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200" u="none" strike="noStrike" dirty="0">
                          <a:effectLst/>
                        </a:rPr>
                        <a:t>a-Sham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200" u="none" strike="noStrike">
                          <a:effectLst/>
                        </a:rPr>
                        <a:t>0.02033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515596202"/>
                  </a:ext>
                </a:extLst>
              </a:tr>
              <a:tr h="37929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200" u="none" strike="noStrike" dirty="0">
                          <a:effectLst/>
                        </a:rPr>
                        <a:t>a-Sham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200" u="none" strike="noStrike" dirty="0">
                          <a:effectLst/>
                        </a:rPr>
                        <a:t>0.79967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2605080207"/>
                  </a:ext>
                </a:extLst>
              </a:tr>
              <a:tr h="37929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200" u="none" strike="noStrike">
                          <a:effectLst/>
                        </a:rPr>
                        <a:t>b-control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200" u="none" strike="noStrike" dirty="0">
                          <a:effectLst/>
                        </a:rPr>
                        <a:t>11.5101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2288291112"/>
                  </a:ext>
                </a:extLst>
              </a:tr>
              <a:tr h="37929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200" u="none" strike="noStrike">
                          <a:effectLst/>
                        </a:rPr>
                        <a:t>b-control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200" u="none" strike="noStrike" dirty="0">
                          <a:effectLst/>
                        </a:rPr>
                        <a:t>9.88763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4261830001"/>
                  </a:ext>
                </a:extLst>
              </a:tr>
              <a:tr h="37929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200" u="none" strike="noStrike">
                          <a:effectLst/>
                        </a:rPr>
                        <a:t>b-control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200" u="none" strike="noStrike" dirty="0">
                          <a:effectLst/>
                        </a:rPr>
                        <a:t>12.514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699021769"/>
                  </a:ext>
                </a:extLst>
              </a:tr>
              <a:tr h="37929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200" u="none" strike="noStrike" dirty="0">
                          <a:effectLst/>
                        </a:rPr>
                        <a:t>c-</a:t>
                      </a:r>
                      <a:r>
                        <a:rPr lang="en-AU" sz="1200" u="none" strike="noStrike" dirty="0" err="1">
                          <a:effectLst/>
                        </a:rPr>
                        <a:t>telmi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200" u="none" strike="noStrike" dirty="0">
                          <a:effectLst/>
                        </a:rPr>
                        <a:t>6.771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4128163373"/>
                  </a:ext>
                </a:extLst>
              </a:tr>
              <a:tr h="37929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200" u="none" strike="noStrike" dirty="0">
                          <a:effectLst/>
                        </a:rPr>
                        <a:t>c-</a:t>
                      </a:r>
                      <a:r>
                        <a:rPr lang="en-AU" sz="1200" u="none" strike="noStrike" dirty="0" err="1">
                          <a:effectLst/>
                        </a:rPr>
                        <a:t>telmi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200" u="none" strike="noStrike" dirty="0">
                          <a:effectLst/>
                        </a:rPr>
                        <a:t>9.424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1579617098"/>
                  </a:ext>
                </a:extLst>
              </a:tr>
              <a:tr h="37929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200" u="none" strike="noStrike">
                          <a:effectLst/>
                        </a:rPr>
                        <a:t>c-telmi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200" u="none" strike="noStrike" dirty="0">
                          <a:effectLst/>
                        </a:rPr>
                        <a:t>8.72067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1600866709"/>
                  </a:ext>
                </a:extLst>
              </a:tr>
              <a:tr h="37929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200" u="none" strike="noStrike" dirty="0">
                          <a:effectLst/>
                        </a:rPr>
                        <a:t>f-PSX64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200" u="none" strike="noStrike" dirty="0">
                          <a:effectLst/>
                        </a:rPr>
                        <a:t>10.074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2843989464"/>
                  </a:ext>
                </a:extLst>
              </a:tr>
              <a:tr h="37929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200" u="none" strike="noStrike">
                          <a:effectLst/>
                        </a:rPr>
                        <a:t>f-PSX6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1200" u="none" strike="noStrike" dirty="0">
                          <a:effectLst/>
                        </a:rPr>
                        <a:t>8.10333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ctr"/>
                </a:tc>
                <a:extLst>
                  <a:ext uri="{0D108BD9-81ED-4DB2-BD59-A6C34878D82A}">
                    <a16:rowId xmlns:a16="http://schemas.microsoft.com/office/drawing/2014/main" val="3301937198"/>
                  </a:ext>
                </a:extLst>
              </a:tr>
              <a:tr h="379295"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>
                          <a:effectLst/>
                        </a:rPr>
                        <a:t>f-PSX64</a:t>
                      </a:r>
                      <a:endParaRPr lang="en-AU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200" u="none" strike="noStrike" dirty="0">
                          <a:effectLst/>
                        </a:rPr>
                        <a:t>5.73</a:t>
                      </a:r>
                      <a:endParaRPr lang="en-A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218586234"/>
                  </a:ext>
                </a:extLst>
              </a:tr>
            </a:tbl>
          </a:graphicData>
        </a:graphic>
      </p:graphicFrame>
      <p:graphicFrame>
        <p:nvGraphicFramePr>
          <p:cNvPr id="23" name="Table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63090896"/>
              </p:ext>
            </p:extLst>
          </p:nvPr>
        </p:nvGraphicFramePr>
        <p:xfrm>
          <a:off x="10184212" y="522675"/>
          <a:ext cx="1401429" cy="48198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54853">
                  <a:extLst>
                    <a:ext uri="{9D8B030D-6E8A-4147-A177-3AD203B41FA5}">
                      <a16:colId xmlns:a16="http://schemas.microsoft.com/office/drawing/2014/main" val="3246364969"/>
                    </a:ext>
                  </a:extLst>
                </a:gridCol>
                <a:gridCol w="546576">
                  <a:extLst>
                    <a:ext uri="{9D8B030D-6E8A-4147-A177-3AD203B41FA5}">
                      <a16:colId xmlns:a16="http://schemas.microsoft.com/office/drawing/2014/main" val="3821082384"/>
                    </a:ext>
                  </a:extLst>
                </a:gridCol>
              </a:tblGrid>
              <a:tr h="169456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 dirty="0">
                          <a:effectLst/>
                        </a:rPr>
                        <a:t> 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b="1" u="none" strike="noStrike">
                          <a:effectLst/>
                        </a:rPr>
                        <a:t>CD68</a:t>
                      </a:r>
                      <a:endParaRPr lang="en-AU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b"/>
                </a:tc>
                <a:extLst>
                  <a:ext uri="{0D108BD9-81ED-4DB2-BD59-A6C34878D82A}">
                    <a16:rowId xmlns:a16="http://schemas.microsoft.com/office/drawing/2014/main" val="2977354584"/>
                  </a:ext>
                </a:extLst>
              </a:tr>
              <a:tr h="25381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a-Sham     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b="0" u="none" strike="noStrike" dirty="0">
                          <a:effectLst/>
                        </a:rPr>
                        <a:t>0.23025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extLst>
                  <a:ext uri="{0D108BD9-81ED-4DB2-BD59-A6C34878D82A}">
                    <a16:rowId xmlns:a16="http://schemas.microsoft.com/office/drawing/2014/main" val="1759078047"/>
                  </a:ext>
                </a:extLst>
              </a:tr>
              <a:tr h="25381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a-Sham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b="0" u="none" strike="noStrike" dirty="0">
                          <a:effectLst/>
                        </a:rPr>
                        <a:t>0.3208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extLst>
                  <a:ext uri="{0D108BD9-81ED-4DB2-BD59-A6C34878D82A}">
                    <a16:rowId xmlns:a16="http://schemas.microsoft.com/office/drawing/2014/main" val="3711609594"/>
                  </a:ext>
                </a:extLst>
              </a:tr>
              <a:tr h="25381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a-Sham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0.4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extLst>
                  <a:ext uri="{0D108BD9-81ED-4DB2-BD59-A6C34878D82A}">
                    <a16:rowId xmlns:a16="http://schemas.microsoft.com/office/drawing/2014/main" val="1321484455"/>
                  </a:ext>
                </a:extLst>
              </a:tr>
              <a:tr h="25381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>
                          <a:effectLst/>
                        </a:rPr>
                        <a:t>b-control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5.1685556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extLst>
                  <a:ext uri="{0D108BD9-81ED-4DB2-BD59-A6C34878D82A}">
                    <a16:rowId xmlns:a16="http://schemas.microsoft.com/office/drawing/2014/main" val="3566694737"/>
                  </a:ext>
                </a:extLst>
              </a:tr>
              <a:tr h="25381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b-control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4.7344444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extLst>
                  <a:ext uri="{0D108BD9-81ED-4DB2-BD59-A6C34878D82A}">
                    <a16:rowId xmlns:a16="http://schemas.microsoft.com/office/drawing/2014/main" val="501495602"/>
                  </a:ext>
                </a:extLst>
              </a:tr>
              <a:tr h="25381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>
                          <a:effectLst/>
                        </a:rPr>
                        <a:t>b-control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14.4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extLst>
                  <a:ext uri="{0D108BD9-81ED-4DB2-BD59-A6C34878D82A}">
                    <a16:rowId xmlns:a16="http://schemas.microsoft.com/office/drawing/2014/main" val="4224487264"/>
                  </a:ext>
                </a:extLst>
              </a:tr>
              <a:tr h="25381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>
                          <a:effectLst/>
                        </a:rPr>
                        <a:t>c-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3.835875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extLst>
                  <a:ext uri="{0D108BD9-81ED-4DB2-BD59-A6C34878D82A}">
                    <a16:rowId xmlns:a16="http://schemas.microsoft.com/office/drawing/2014/main" val="222982353"/>
                  </a:ext>
                </a:extLst>
              </a:tr>
              <a:tr h="25381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c-</a:t>
                      </a:r>
                      <a:r>
                        <a:rPr lang="en-AU" sz="900" u="none" strike="noStrike" dirty="0" err="1">
                          <a:effectLst/>
                        </a:rPr>
                        <a:t>telmi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2.8381667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extLst>
                  <a:ext uri="{0D108BD9-81ED-4DB2-BD59-A6C34878D82A}">
                    <a16:rowId xmlns:a16="http://schemas.microsoft.com/office/drawing/2014/main" val="1341400649"/>
                  </a:ext>
                </a:extLst>
              </a:tr>
              <a:tr h="25381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>
                          <a:effectLst/>
                        </a:rPr>
                        <a:t>c-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9.7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extLst>
                  <a:ext uri="{0D108BD9-81ED-4DB2-BD59-A6C34878D82A}">
                    <a16:rowId xmlns:a16="http://schemas.microsoft.com/office/drawing/2014/main" val="3141024365"/>
                  </a:ext>
                </a:extLst>
              </a:tr>
              <a:tr h="25381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>
                          <a:effectLst/>
                        </a:rPr>
                        <a:t>d-SSA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2.94575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extLst>
                  <a:ext uri="{0D108BD9-81ED-4DB2-BD59-A6C34878D82A}">
                    <a16:rowId xmlns:a16="http://schemas.microsoft.com/office/drawing/2014/main" val="3750214640"/>
                  </a:ext>
                </a:extLst>
              </a:tr>
              <a:tr h="25381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>
                          <a:effectLst/>
                        </a:rPr>
                        <a:t>d-SSA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4.637125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extLst>
                  <a:ext uri="{0D108BD9-81ED-4DB2-BD59-A6C34878D82A}">
                    <a16:rowId xmlns:a16="http://schemas.microsoft.com/office/drawing/2014/main" val="1198951714"/>
                  </a:ext>
                </a:extLst>
              </a:tr>
              <a:tr h="335493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d-SSAO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4.56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extLst>
                  <a:ext uri="{0D108BD9-81ED-4DB2-BD59-A6C34878D82A}">
                    <a16:rowId xmlns:a16="http://schemas.microsoft.com/office/drawing/2014/main" val="3026649534"/>
                  </a:ext>
                </a:extLst>
              </a:tr>
              <a:tr h="25381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e-SSAO/</a:t>
                      </a:r>
                      <a:r>
                        <a:rPr lang="en-AU" sz="900" u="none" strike="noStrike" dirty="0" err="1">
                          <a:effectLst/>
                        </a:rPr>
                        <a:t>telmi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6.659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extLst>
                  <a:ext uri="{0D108BD9-81ED-4DB2-BD59-A6C34878D82A}">
                    <a16:rowId xmlns:a16="http://schemas.microsoft.com/office/drawing/2014/main" val="3858826184"/>
                  </a:ext>
                </a:extLst>
              </a:tr>
              <a:tr h="25381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e-SSAO/</a:t>
                      </a:r>
                      <a:r>
                        <a:rPr lang="en-AU" sz="900" u="none" strike="noStrike" dirty="0" err="1">
                          <a:effectLst/>
                        </a:rPr>
                        <a:t>telmi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0.272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extLst>
                  <a:ext uri="{0D108BD9-81ED-4DB2-BD59-A6C34878D82A}">
                    <a16:rowId xmlns:a16="http://schemas.microsoft.com/office/drawing/2014/main" val="2909133828"/>
                  </a:ext>
                </a:extLst>
              </a:tr>
              <a:tr h="25381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>
                          <a:effectLst/>
                        </a:rPr>
                        <a:t>e-SSAO/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1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extLst>
                  <a:ext uri="{0D108BD9-81ED-4DB2-BD59-A6C34878D82A}">
                    <a16:rowId xmlns:a16="http://schemas.microsoft.com/office/drawing/2014/main" val="2850210286"/>
                  </a:ext>
                </a:extLst>
              </a:tr>
              <a:tr h="25381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>
                          <a:effectLst/>
                        </a:rPr>
                        <a:t>f-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4.538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extLst>
                  <a:ext uri="{0D108BD9-81ED-4DB2-BD59-A6C34878D82A}">
                    <a16:rowId xmlns:a16="http://schemas.microsoft.com/office/drawing/2014/main" val="1058995914"/>
                  </a:ext>
                </a:extLst>
              </a:tr>
              <a:tr h="253815"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>
                          <a:effectLst/>
                        </a:rPr>
                        <a:t>f-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AU" sz="900" u="none" strike="noStrike" dirty="0">
                          <a:effectLst/>
                        </a:rPr>
                        <a:t>7.7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ctr"/>
                </a:tc>
                <a:extLst>
                  <a:ext uri="{0D108BD9-81ED-4DB2-BD59-A6C34878D82A}">
                    <a16:rowId xmlns:a16="http://schemas.microsoft.com/office/drawing/2014/main" val="1045363213"/>
                  </a:ext>
                </a:extLst>
              </a:tr>
              <a:tr h="253815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f-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 dirty="0">
                          <a:effectLst/>
                        </a:rPr>
                        <a:t>6.384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67" marR="2467" marT="2467" marB="0" anchor="b"/>
                </a:tc>
                <a:extLst>
                  <a:ext uri="{0D108BD9-81ED-4DB2-BD59-A6C34878D82A}">
                    <a16:rowId xmlns:a16="http://schemas.microsoft.com/office/drawing/2014/main" val="2713120666"/>
                  </a:ext>
                </a:extLst>
              </a:tr>
            </a:tbl>
          </a:graphicData>
        </a:graphic>
      </p:graphicFrame>
      <p:graphicFrame>
        <p:nvGraphicFramePr>
          <p:cNvPr id="24" name="Object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8253185"/>
              </p:ext>
            </p:extLst>
          </p:nvPr>
        </p:nvGraphicFramePr>
        <p:xfrm>
          <a:off x="7847859" y="5342473"/>
          <a:ext cx="1685636" cy="14589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5" name="Prism 8" r:id="rId9" imgW="3445772" imgH="2982991" progId="Prism8.Document">
                  <p:embed/>
                </p:oleObj>
              </mc:Choice>
              <mc:Fallback>
                <p:oleObj name="Prism 8" r:id="rId9" imgW="3445772" imgH="2982991" progId="Prism8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847859" y="5342473"/>
                        <a:ext cx="1685636" cy="14589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324048"/>
              </p:ext>
            </p:extLst>
          </p:nvPr>
        </p:nvGraphicFramePr>
        <p:xfrm>
          <a:off x="9889136" y="5240376"/>
          <a:ext cx="1981143" cy="17162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6" name="Prism 8" r:id="rId11" imgW="3442532" imgH="2982991" progId="Prism8.Document">
                  <p:embed/>
                </p:oleObj>
              </mc:Choice>
              <mc:Fallback>
                <p:oleObj name="Prism 8" r:id="rId11" imgW="3442532" imgH="2982991" progId="Prism8.Document">
                  <p:embed/>
                  <p:pic>
                    <p:nvPicPr>
                      <p:cNvPr id="10" name="Object 9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9889136" y="5240376"/>
                        <a:ext cx="1981143" cy="171626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TextBox 6"/>
          <p:cNvSpPr txBox="1">
            <a:spLocks noChangeArrowheads="1"/>
          </p:cNvSpPr>
          <p:nvPr/>
        </p:nvSpPr>
        <p:spPr bwMode="auto">
          <a:xfrm>
            <a:off x="10465170" y="130564"/>
            <a:ext cx="829073" cy="369332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AU" altLang="en-US" b="1" dirty="0"/>
              <a:t>Figs 6E</a:t>
            </a:r>
          </a:p>
        </p:txBody>
      </p:sp>
    </p:spTree>
    <p:extLst>
      <p:ext uri="{BB962C8B-B14F-4D97-AF65-F5344CB8AC3E}">
        <p14:creationId xmlns:p14="http://schemas.microsoft.com/office/powerpoint/2010/main" val="227955686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71393135"/>
              </p:ext>
            </p:extLst>
          </p:nvPr>
        </p:nvGraphicFramePr>
        <p:xfrm>
          <a:off x="7300427" y="761028"/>
          <a:ext cx="2438400" cy="459559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val="1434220103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37452317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530021372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606666485"/>
                    </a:ext>
                  </a:extLst>
                </a:gridCol>
              </a:tblGrid>
              <a:tr h="270329"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Average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82752423"/>
                  </a:ext>
                </a:extLst>
              </a:tr>
              <a:tr h="270329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SHAM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>
                          <a:effectLst/>
                        </a:rPr>
                        <a:t>0.052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>
                          <a:effectLst/>
                        </a:rPr>
                        <a:t>0.052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979595414"/>
                  </a:ext>
                </a:extLst>
              </a:tr>
              <a:tr h="270329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SHAM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>
                          <a:effectLst/>
                        </a:rPr>
                        <a:t>0.091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726904489"/>
                  </a:ext>
                </a:extLst>
              </a:tr>
              <a:tr h="270329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SHAM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>
                          <a:effectLst/>
                        </a:rPr>
                        <a:t>0.013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771672437"/>
                  </a:ext>
                </a:extLst>
              </a:tr>
              <a:tr h="270329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UUO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>
                          <a:effectLst/>
                        </a:rPr>
                        <a:t>6.04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>
                          <a:effectLst/>
                        </a:rPr>
                        <a:t>6.6196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601815573"/>
                  </a:ext>
                </a:extLst>
              </a:tr>
              <a:tr h="270329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UUO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>
                          <a:effectLst/>
                        </a:rPr>
                        <a:t>2.145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645691773"/>
                  </a:ext>
                </a:extLst>
              </a:tr>
              <a:tr h="270329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UUO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>
                          <a:effectLst/>
                        </a:rPr>
                        <a:t>6.222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559486520"/>
                  </a:ext>
                </a:extLst>
              </a:tr>
              <a:tr h="270329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UUO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>
                          <a:effectLst/>
                        </a:rPr>
                        <a:t>6.931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602605172"/>
                  </a:ext>
                </a:extLst>
              </a:tr>
              <a:tr h="270329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UUO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>
                          <a:effectLst/>
                        </a:rPr>
                        <a:t>11.76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677863540"/>
                  </a:ext>
                </a:extLst>
              </a:tr>
              <a:tr h="270329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TELMI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>
                          <a:effectLst/>
                        </a:rPr>
                        <a:t>1.468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>
                          <a:effectLst/>
                        </a:rPr>
                        <a:t>5.544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688134906"/>
                  </a:ext>
                </a:extLst>
              </a:tr>
              <a:tr h="270329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TELMI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>
                          <a:effectLst/>
                        </a:rPr>
                        <a:t>9.4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416878533"/>
                  </a:ext>
                </a:extLst>
              </a:tr>
              <a:tr h="270329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TELMI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>
                          <a:effectLst/>
                        </a:rPr>
                        <a:t>10.19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961731920"/>
                  </a:ext>
                </a:extLst>
              </a:tr>
              <a:tr h="270329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TELMI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>
                          <a:effectLst/>
                        </a:rPr>
                        <a:t>1.118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427754248"/>
                  </a:ext>
                </a:extLst>
              </a:tr>
              <a:tr h="270329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PSX64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>
                          <a:effectLst/>
                        </a:rPr>
                        <a:t>1.898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 dirty="0">
                          <a:effectLst/>
                        </a:rPr>
                        <a:t>1.0415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514064034"/>
                  </a:ext>
                </a:extLst>
              </a:tr>
              <a:tr h="270329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PSX64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>
                          <a:effectLst/>
                        </a:rPr>
                        <a:t>0.043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4252503053"/>
                  </a:ext>
                </a:extLst>
              </a:tr>
              <a:tr h="270329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PSX64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>
                          <a:effectLst/>
                        </a:rPr>
                        <a:t>1.892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521584590"/>
                  </a:ext>
                </a:extLst>
              </a:tr>
              <a:tr h="270329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PSX64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>
                          <a:effectLst/>
                        </a:rPr>
                        <a:t>0.333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464469694"/>
                  </a:ext>
                </a:extLst>
              </a:tr>
            </a:tbl>
          </a:graphicData>
        </a:graphic>
      </p:graphicFrame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17496324"/>
              </p:ext>
            </p:extLst>
          </p:nvPr>
        </p:nvGraphicFramePr>
        <p:xfrm>
          <a:off x="7300427" y="5458281"/>
          <a:ext cx="2438400" cy="93662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66987">
                  <a:extLst>
                    <a:ext uri="{9D8B030D-6E8A-4147-A177-3AD203B41FA5}">
                      <a16:colId xmlns:a16="http://schemas.microsoft.com/office/drawing/2014/main" val="3791766003"/>
                    </a:ext>
                  </a:extLst>
                </a:gridCol>
                <a:gridCol w="1571413">
                  <a:extLst>
                    <a:ext uri="{9D8B030D-6E8A-4147-A177-3AD203B41FA5}">
                      <a16:colId xmlns:a16="http://schemas.microsoft.com/office/drawing/2014/main" val="747585196"/>
                    </a:ext>
                  </a:extLst>
                </a:gridCol>
              </a:tblGrid>
              <a:tr h="187325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 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 dirty="0">
                          <a:effectLst/>
                        </a:rPr>
                        <a:t>Average/ group </a:t>
                      </a:r>
                      <a:endParaRPr lang="en-AU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23156975"/>
                  </a:ext>
                </a:extLst>
              </a:tr>
              <a:tr h="187325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SHAM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>
                          <a:effectLst/>
                        </a:rPr>
                        <a:t>0.052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384122036"/>
                  </a:ext>
                </a:extLst>
              </a:tr>
              <a:tr h="187325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UUO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>
                          <a:effectLst/>
                        </a:rPr>
                        <a:t>6.6196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573421733"/>
                  </a:ext>
                </a:extLst>
              </a:tr>
              <a:tr h="187325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TELMI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 dirty="0">
                          <a:effectLst/>
                        </a:rPr>
                        <a:t>5.544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460475796"/>
                  </a:ext>
                </a:extLst>
              </a:tr>
              <a:tr h="187325">
                <a:tc>
                  <a:txBody>
                    <a:bodyPr/>
                    <a:lstStyle/>
                    <a:p>
                      <a:pPr algn="l" fontAlgn="b"/>
                      <a:r>
                        <a:rPr lang="en-AU" sz="1100" u="none" strike="noStrike">
                          <a:effectLst/>
                        </a:rPr>
                        <a:t>PSX64</a:t>
                      </a:r>
                      <a:endParaRPr lang="en-AU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1100" u="none" strike="noStrike" dirty="0">
                          <a:effectLst/>
                        </a:rPr>
                        <a:t>1.0415</a:t>
                      </a:r>
                      <a:endParaRPr lang="en-A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258220161"/>
                  </a:ext>
                </a:extLst>
              </a:tr>
            </a:tbl>
          </a:graphicData>
        </a:graphic>
      </p:graphicFrame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3355609"/>
              </p:ext>
            </p:extLst>
          </p:nvPr>
        </p:nvGraphicFramePr>
        <p:xfrm>
          <a:off x="209037" y="761030"/>
          <a:ext cx="3518220" cy="563387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19461">
                  <a:extLst>
                    <a:ext uri="{9D8B030D-6E8A-4147-A177-3AD203B41FA5}">
                      <a16:colId xmlns:a16="http://schemas.microsoft.com/office/drawing/2014/main" val="762379696"/>
                    </a:ext>
                  </a:extLst>
                </a:gridCol>
                <a:gridCol w="885018">
                  <a:extLst>
                    <a:ext uri="{9D8B030D-6E8A-4147-A177-3AD203B41FA5}">
                      <a16:colId xmlns:a16="http://schemas.microsoft.com/office/drawing/2014/main" val="304951062"/>
                    </a:ext>
                  </a:extLst>
                </a:gridCol>
                <a:gridCol w="939649">
                  <a:extLst>
                    <a:ext uri="{9D8B030D-6E8A-4147-A177-3AD203B41FA5}">
                      <a16:colId xmlns:a16="http://schemas.microsoft.com/office/drawing/2014/main" val="3522077383"/>
                    </a:ext>
                  </a:extLst>
                </a:gridCol>
                <a:gridCol w="874092">
                  <a:extLst>
                    <a:ext uri="{9D8B030D-6E8A-4147-A177-3AD203B41FA5}">
                      <a16:colId xmlns:a16="http://schemas.microsoft.com/office/drawing/2014/main" val="3197804815"/>
                    </a:ext>
                  </a:extLst>
                </a:gridCol>
              </a:tblGrid>
              <a:tr h="209687"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Slide numbers 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Conditions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Individual data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Total % Staining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2000555932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05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0526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649389558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000638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1308107574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06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09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2918766599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02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2241956699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6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006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01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1506326694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6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SHAM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00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1004899025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76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6.0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454919172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17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35958328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81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2577556947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28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173053815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0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22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.14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1793802426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0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44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2166677707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0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26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968586608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0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46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2708625672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0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74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3479938819"/>
                  </a:ext>
                </a:extLst>
              </a:tr>
              <a:tr h="182014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56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6.22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3998521813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91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766967404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07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1898494007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91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2181969407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74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3815194139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0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 dirty="0">
                          <a:effectLst/>
                        </a:rPr>
                        <a:t>2.241</a:t>
                      </a:r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1.7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661465373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0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2293439959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0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.64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131479993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0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5.0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1351954807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92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6.93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883333605"/>
                  </a:ext>
                </a:extLst>
              </a:tr>
              <a:tr h="209687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UUO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5.0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732" marR="2732" marT="2732" marB="0" anchor="b"/>
                </a:tc>
                <a:extLst>
                  <a:ext uri="{0D108BD9-81ED-4DB2-BD59-A6C34878D82A}">
                    <a16:rowId xmlns:a16="http://schemas.microsoft.com/office/drawing/2014/main" val="2439538477"/>
                  </a:ext>
                </a:extLst>
              </a:tr>
            </a:tbl>
          </a:graphicData>
        </a:graphic>
      </p:graphicFrame>
      <p:graphicFrame>
        <p:nvGraphicFramePr>
          <p:cNvPr id="11" name="Tab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48809559"/>
              </p:ext>
            </p:extLst>
          </p:nvPr>
        </p:nvGraphicFramePr>
        <p:xfrm>
          <a:off x="3930643" y="761044"/>
          <a:ext cx="3166398" cy="56869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37515">
                  <a:extLst>
                    <a:ext uri="{9D8B030D-6E8A-4147-A177-3AD203B41FA5}">
                      <a16:colId xmlns:a16="http://schemas.microsoft.com/office/drawing/2014/main" val="4003946557"/>
                    </a:ext>
                  </a:extLst>
                </a:gridCol>
                <a:gridCol w="796516">
                  <a:extLst>
                    <a:ext uri="{9D8B030D-6E8A-4147-A177-3AD203B41FA5}">
                      <a16:colId xmlns:a16="http://schemas.microsoft.com/office/drawing/2014/main" val="1407058749"/>
                    </a:ext>
                  </a:extLst>
                </a:gridCol>
                <a:gridCol w="845684">
                  <a:extLst>
                    <a:ext uri="{9D8B030D-6E8A-4147-A177-3AD203B41FA5}">
                      <a16:colId xmlns:a16="http://schemas.microsoft.com/office/drawing/2014/main" val="1113899453"/>
                    </a:ext>
                  </a:extLst>
                </a:gridCol>
                <a:gridCol w="786683">
                  <a:extLst>
                    <a:ext uri="{9D8B030D-6E8A-4147-A177-3AD203B41FA5}">
                      <a16:colId xmlns:a16="http://schemas.microsoft.com/office/drawing/2014/main" val="2250318463"/>
                    </a:ext>
                  </a:extLst>
                </a:gridCol>
              </a:tblGrid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13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46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904157205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24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1838182865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01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4244531391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07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2715305444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42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9.47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1534959355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.66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854032994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.1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962313761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38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2267078884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87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1816101190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56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0.19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10383932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25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2621873603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.38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382751101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.35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2111791187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64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1751194111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4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32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2098630607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52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11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3109907201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2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TELMI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59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1018431981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17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33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1146282272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3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16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1457642514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5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3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89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622226871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5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64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2692765325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5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216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2516329781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55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69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4219479047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5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01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043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307851476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57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02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2534463855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5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27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1.892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1815712175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5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466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530206516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5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308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572614836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5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776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23641697"/>
                  </a:ext>
                </a:extLst>
              </a:tr>
              <a:tr h="189565"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59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U" sz="900" u="none" strike="noStrike">
                          <a:effectLst/>
                        </a:rPr>
                        <a:t>PSX64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AU" sz="900" u="none" strike="noStrike">
                          <a:effectLst/>
                        </a:rPr>
                        <a:t>0.071</a:t>
                      </a:r>
                      <a:endParaRPr lang="en-AU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AU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458" marR="2458" marT="2458" marB="0" anchor="b"/>
                </a:tc>
                <a:extLst>
                  <a:ext uri="{0D108BD9-81ED-4DB2-BD59-A6C34878D82A}">
                    <a16:rowId xmlns:a16="http://schemas.microsoft.com/office/drawing/2014/main" val="1846820333"/>
                  </a:ext>
                </a:extLst>
              </a:tr>
            </a:tbl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97173039"/>
              </p:ext>
            </p:extLst>
          </p:nvPr>
        </p:nvGraphicFramePr>
        <p:xfrm>
          <a:off x="9827361" y="2475880"/>
          <a:ext cx="2064190" cy="19326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6" name="Prism 8" r:id="rId3" imgW="3437852" imgH="3219181" progId="Prism8.Document">
                  <p:embed/>
                </p:oleObj>
              </mc:Choice>
              <mc:Fallback>
                <p:oleObj name="Prism 8" r:id="rId3" imgW="3437852" imgH="321918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827361" y="2475880"/>
                        <a:ext cx="2064190" cy="19326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/>
          <p:cNvSpPr/>
          <p:nvPr/>
        </p:nvSpPr>
        <p:spPr>
          <a:xfrm>
            <a:off x="604284" y="294382"/>
            <a:ext cx="7841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AU" altLang="en-US" b="1" dirty="0"/>
              <a:t>Fig 6F 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416814503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237004" y="903076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Figure 7</a:t>
            </a:r>
          </a:p>
        </p:txBody>
      </p:sp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54065740"/>
              </p:ext>
            </p:extLst>
          </p:nvPr>
        </p:nvGraphicFramePr>
        <p:xfrm>
          <a:off x="4531720" y="2309935"/>
          <a:ext cx="3552326" cy="22785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0" name="Prism 8" r:id="rId3" imgW="3899712" imgH="2501247" progId="Prism8.Document">
                  <p:embed/>
                </p:oleObj>
              </mc:Choice>
              <mc:Fallback>
                <p:oleObj name="Prism 8" r:id="rId3" imgW="3899712" imgH="250124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531720" y="2309935"/>
                        <a:ext cx="3552326" cy="22785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Tab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27796599"/>
              </p:ext>
            </p:extLst>
          </p:nvPr>
        </p:nvGraphicFramePr>
        <p:xfrm>
          <a:off x="1899804" y="1392865"/>
          <a:ext cx="1981080" cy="457199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76696">
                  <a:extLst>
                    <a:ext uri="{9D8B030D-6E8A-4147-A177-3AD203B41FA5}">
                      <a16:colId xmlns:a16="http://schemas.microsoft.com/office/drawing/2014/main" val="2596620096"/>
                    </a:ext>
                  </a:extLst>
                </a:gridCol>
                <a:gridCol w="704384">
                  <a:extLst>
                    <a:ext uri="{9D8B030D-6E8A-4147-A177-3AD203B41FA5}">
                      <a16:colId xmlns:a16="http://schemas.microsoft.com/office/drawing/2014/main" val="304237921"/>
                    </a:ext>
                  </a:extLst>
                </a:gridCol>
              </a:tblGrid>
              <a:tr h="26894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A Sham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0.016613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642172264"/>
                  </a:ext>
                </a:extLst>
              </a:tr>
              <a:tr h="26894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A Sham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0.031565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009473891"/>
                  </a:ext>
                </a:extLst>
              </a:tr>
              <a:tr h="26894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A Sham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0.019177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716038803"/>
                  </a:ext>
                </a:extLst>
              </a:tr>
              <a:tr h="26894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A Sham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0.02167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840351694"/>
                  </a:ext>
                </a:extLst>
              </a:tr>
              <a:tr h="26894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B UUO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0.181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10165536"/>
                  </a:ext>
                </a:extLst>
              </a:tr>
              <a:tr h="26894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B UUO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0.070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639761240"/>
                  </a:ext>
                </a:extLst>
              </a:tr>
              <a:tr h="26894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B UUO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0.14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929816063"/>
                  </a:ext>
                </a:extLst>
              </a:tr>
              <a:tr h="26894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B UUO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0.108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181550865"/>
                  </a:ext>
                </a:extLst>
              </a:tr>
              <a:tr h="26894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C Telmi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0.113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922587860"/>
                  </a:ext>
                </a:extLst>
              </a:tr>
              <a:tr h="26894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C Telmi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0.0038429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104408670"/>
                  </a:ext>
                </a:extLst>
              </a:tr>
              <a:tr h="26894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C Telmi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0.022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731943419"/>
                  </a:ext>
                </a:extLst>
              </a:tr>
              <a:tr h="26894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C Telmi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0.0232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3182219951"/>
                  </a:ext>
                </a:extLst>
              </a:tr>
              <a:tr h="26894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C Telmi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0.0272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4288460235"/>
                  </a:ext>
                </a:extLst>
              </a:tr>
              <a:tr h="26894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D PSX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0.0291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607070490"/>
                  </a:ext>
                </a:extLst>
              </a:tr>
              <a:tr h="26894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D PSX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0.0316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953010073"/>
                  </a:ext>
                </a:extLst>
              </a:tr>
              <a:tr h="26894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D PSX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>
                          <a:effectLst/>
                        </a:rPr>
                        <a:t>0.0162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2101987613"/>
                  </a:ext>
                </a:extLst>
              </a:tr>
              <a:tr h="268941">
                <a:tc>
                  <a:txBody>
                    <a:bodyPr/>
                    <a:lstStyle/>
                    <a:p>
                      <a:pPr algn="l" rtl="0" fontAlgn="b"/>
                      <a:r>
                        <a:rPr lang="en-AU" sz="1000" u="none" strike="noStrike">
                          <a:effectLst/>
                        </a:rPr>
                        <a:t>D PSX64</a:t>
                      </a:r>
                      <a:endParaRPr lang="en-AU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en-AU" sz="1000" u="none" strike="noStrike" dirty="0">
                          <a:effectLst/>
                        </a:rPr>
                        <a:t>0.007</a:t>
                      </a:r>
                      <a:endParaRPr lang="en-AU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175" marR="3175" marT="3175" marB="0" anchor="b"/>
                </a:tc>
                <a:extLst>
                  <a:ext uri="{0D108BD9-81ED-4DB2-BD59-A6C34878D82A}">
                    <a16:rowId xmlns:a16="http://schemas.microsoft.com/office/drawing/2014/main" val="184794013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889123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412</TotalTime>
  <Words>1483</Words>
  <Application>Microsoft Office PowerPoint</Application>
  <PresentationFormat>Widescreen</PresentationFormat>
  <Paragraphs>1256</Paragraphs>
  <Slides>9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nia Saad</dc:creator>
  <cp:lastModifiedBy>Amaya Reik</cp:lastModifiedBy>
  <cp:revision>149</cp:revision>
  <cp:lastPrinted>2022-01-05T15:01:18Z</cp:lastPrinted>
  <dcterms:created xsi:type="dcterms:W3CDTF">2021-10-12T00:28:25Z</dcterms:created>
  <dcterms:modified xsi:type="dcterms:W3CDTF">2022-01-05T16:12:27Z</dcterms:modified>
</cp:coreProperties>
</file>